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8A97A-FB99-453B-99DE-F93F750A11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D8A289-C2EA-453C-8EBE-03CBFEAA96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28416B-F516-430E-B966-AC5134D81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F15F33-6DB1-4E1E-9658-C194EEFE7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E23C1D-6117-401A-8284-1941421E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201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54BBD-E8BA-4D7E-BBE5-22A263DDE0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4345E9-2E53-4CF0-BB44-602172EA2E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AF3706-DD92-4015-8FC8-8404D6B90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610D3-E08A-44EB-9726-3AE0094D8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174154-BE6A-4250-97B1-489FEEB9B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719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2615A3-756F-4045-8652-DA621385D6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DEE79C-56AC-4D86-A290-360B00A91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462F9-85D6-4D72-9BB9-3198BA80A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B56995-207B-442B-9A32-55DE871B5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E08D0E-C4BA-4D25-BDD0-1F7763314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18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DE363-73D8-460B-91B7-91024A72C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EB6A97-F77F-4FE8-90C1-FA4B862FE9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803557-BBCE-40A2-B838-38C2FBCBA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048AD8-2942-4497-B2D0-F556C8B5C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674854-98D7-4419-89B0-481FC9C85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6321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8F896-CADA-4E9D-9510-881142276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834BBA-C3FE-4FF8-AA6E-15A0AD0542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88774C-1871-4846-B14B-5B0D66D59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C24CE-9EDA-421A-A2FD-740D12B18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F34CF-7581-422A-B856-3AE8237C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2948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EFBB6-1089-48F5-893E-D651C138E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DA5E6-7529-4C35-838D-E86425A209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27B49-0CC7-49DC-BD81-2D07710020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FC4106-45BF-4527-A1C4-FCB97E0F0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AF52C7-B152-4D18-AD1E-4F11B2054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BF2D9C-8158-4D51-8C7C-E8AC784A1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344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636D0-12D4-44F3-A2AD-FDAB63EA5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3AB4AF-00D3-4C0D-98A2-7062A59A51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565844-B962-4F19-A1EF-2AFA67CA66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FD5FC2-A81F-409B-A841-3C3005CFB9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057206-B2F6-404D-A1C4-0A39E73CEA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DE58F7-5E9D-4F12-9DD6-391300C7D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99BFF-F481-47A9-A64B-28ADD0CCD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325940-1A69-4276-8494-0448312F2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55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A55FB-BB7B-4CA2-A96A-23819AE67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EED58C-5797-40C0-AF10-2C56BCB6B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04DB6B-BAFF-44AA-A9C5-F74057153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0B9626-1D79-49A6-B9C6-01251760A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454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7C1E07-FD48-44DE-910E-5F19FFD3C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7B71B1-7FB5-43E8-A30A-8F2B8D2A4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54AA91-311E-4B81-953A-3E733874E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912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3574A-BA67-44A9-92F9-72E281EB4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733CE2-A9AA-445C-BC7A-5A1488647A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9C77C4-74A7-4F96-8A87-92C8C69E82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53926B-CBF6-4D58-90FB-49D85246A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12A12B-B9B1-49CE-9DE9-229D8E563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132D0F-39EF-4874-86EB-17DE2FF78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732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91AAB-C3D0-4EFC-93E8-EEC3FF50D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FE54B6-16B1-44E6-8411-46CB504DD6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9F21CA-9C85-44EC-A3A6-9E40786821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B2CB1E-AAB5-48BF-B661-27935505D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080A5B-7039-40C8-A22E-9792C3908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833A37-D157-4DDA-B966-F15B4FD2E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485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A922DA-1C6A-4597-A784-0E848BF70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EB46BC-7126-44B3-88A9-4C2648B3A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910231-AAF9-4823-996F-8D2516748C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33AF6-F19D-47D5-B2A8-CC7136966B4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42BED1-6DCA-47CF-B050-80E7D6E627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67220D-9C19-49B1-9C50-ED3D8CA80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47451-CAA9-4915-98A7-0D133259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53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TextBox 192">
            <a:extLst>
              <a:ext uri="{FF2B5EF4-FFF2-40B4-BE49-F238E27FC236}">
                <a16:creationId xmlns:a16="http://schemas.microsoft.com/office/drawing/2014/main" id="{F2271D25-B33C-46F1-8840-AEED5E32E24C}"/>
              </a:ext>
            </a:extLst>
          </p:cNvPr>
          <p:cNvSpPr txBox="1"/>
          <p:nvPr/>
        </p:nvSpPr>
        <p:spPr>
          <a:xfrm>
            <a:off x="225313" y="5045735"/>
            <a:ext cx="1174713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 Nova" panose="020B0504020202020204" pitchFamily="34" charset="0"/>
              </a:rPr>
              <a:t> </a:t>
            </a:r>
          </a:p>
          <a:p>
            <a:r>
              <a:rPr lang="en-GB" sz="1200" b="1" dirty="0"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GB" sz="1200" b="1" dirty="0">
                <a:latin typeface="Arial Nova" panose="020B0504020202020204" pitchFamily="34" charset="0"/>
              </a:rPr>
              <a:t>Figure S11. Model of possible effects of P1597L mutation on PlexinB1 signalling</a:t>
            </a:r>
            <a:r>
              <a:rPr lang="en-GB" sz="1200" dirty="0">
                <a:latin typeface="Arial Nova" panose="020B0504020202020204" pitchFamily="34" charset="0"/>
              </a:rPr>
              <a:t>. (</a:t>
            </a:r>
            <a:r>
              <a:rPr lang="en-GB" sz="1200" b="1" dirty="0">
                <a:latin typeface="Arial Nova" panose="020B0504020202020204" pitchFamily="34" charset="0"/>
              </a:rPr>
              <a:t>A)  </a:t>
            </a:r>
            <a:r>
              <a:rPr lang="en-GB" sz="1200" dirty="0">
                <a:latin typeface="Arial Nova" panose="020B0504020202020204" pitchFamily="34" charset="0"/>
              </a:rPr>
              <a:t>Wild type PlexinB1 regulates several small GTPases, including Rap and Rho. Wild-type PlexinB1 acts as a GTPase activating protein (GAP) for Rap, catalysing the conversion of </a:t>
            </a:r>
            <a:r>
              <a:rPr lang="en-GB" sz="1200" dirty="0" err="1">
                <a:latin typeface="Arial Nova" panose="020B0504020202020204" pitchFamily="34" charset="0"/>
              </a:rPr>
              <a:t>RapGTP</a:t>
            </a:r>
            <a:r>
              <a:rPr lang="en-GB" sz="1200" dirty="0">
                <a:latin typeface="Arial Nova" panose="020B0504020202020204" pitchFamily="34" charset="0"/>
              </a:rPr>
              <a:t> to inactive </a:t>
            </a:r>
            <a:r>
              <a:rPr lang="en-GB" sz="1200" dirty="0" err="1">
                <a:latin typeface="Arial Nova" panose="020B0504020202020204" pitchFamily="34" charset="0"/>
              </a:rPr>
              <a:t>RapGDP</a:t>
            </a:r>
            <a:r>
              <a:rPr lang="en-GB" sz="1200" dirty="0">
                <a:latin typeface="Arial Nova" panose="020B0504020202020204" pitchFamily="34" charset="0"/>
              </a:rPr>
              <a:t>. WT PlexinB1 also activates p190RhoGAP, promoting the conversion of </a:t>
            </a:r>
            <a:r>
              <a:rPr lang="en-GB" sz="1200" dirty="0" err="1">
                <a:latin typeface="Arial Nova" panose="020B0504020202020204" pitchFamily="34" charset="0"/>
              </a:rPr>
              <a:t>RhoA</a:t>
            </a:r>
            <a:r>
              <a:rPr lang="en-GB" sz="1200" dirty="0">
                <a:latin typeface="Arial Nova" panose="020B0504020202020204" pitchFamily="34" charset="0"/>
              </a:rPr>
              <a:t>-GTP to GDP, and </a:t>
            </a:r>
            <a:r>
              <a:rPr lang="en-GB" sz="1200" dirty="0" err="1">
                <a:latin typeface="Arial Nova" panose="020B0504020202020204" pitchFamily="34" charset="0"/>
              </a:rPr>
              <a:t>PDZRhoGEF</a:t>
            </a:r>
            <a:r>
              <a:rPr lang="en-GB" sz="1200" dirty="0">
                <a:latin typeface="Arial Nova" panose="020B0504020202020204" pitchFamily="34" charset="0"/>
              </a:rPr>
              <a:t>, activating </a:t>
            </a:r>
            <a:r>
              <a:rPr lang="en-GB" sz="1200" dirty="0" err="1">
                <a:latin typeface="Arial Nova" panose="020B0504020202020204" pitchFamily="34" charset="0"/>
              </a:rPr>
              <a:t>RhoA</a:t>
            </a:r>
            <a:r>
              <a:rPr lang="en-GB" sz="1200" dirty="0">
                <a:latin typeface="Arial Nova" panose="020B0504020202020204" pitchFamily="34" charset="0"/>
              </a:rPr>
              <a:t> or C. Overexpression of WT plexinB1 in mouse prostate epithelial cells suppresses MLC2 phosphorylation and invasion possibly through promoting p190RhoGAP activation and/or through its activity as a </a:t>
            </a:r>
            <a:r>
              <a:rPr lang="en-GB" sz="1200" dirty="0" err="1">
                <a:latin typeface="Arial Nova" panose="020B0504020202020204" pitchFamily="34" charset="0"/>
              </a:rPr>
              <a:t>RapGAP</a:t>
            </a:r>
            <a:r>
              <a:rPr lang="en-GB" sz="1200" dirty="0">
                <a:latin typeface="Arial Nova" panose="020B0504020202020204" pitchFamily="34" charset="0"/>
              </a:rPr>
              <a:t>.</a:t>
            </a:r>
          </a:p>
          <a:p>
            <a:r>
              <a:rPr lang="en-GB" sz="1200" b="1" dirty="0">
                <a:latin typeface="Arial Nova" panose="020B0504020202020204" pitchFamily="34" charset="0"/>
              </a:rPr>
              <a:t>(B)</a:t>
            </a:r>
            <a:r>
              <a:rPr lang="en-GB" sz="1200" dirty="0">
                <a:latin typeface="Arial Nova" panose="020B0504020202020204" pitchFamily="34" charset="0"/>
              </a:rPr>
              <a:t> The P1597L mutation in the GAP domain of PlexinB1 is predicted to disrupt the GAP activity of PlexinB1.</a:t>
            </a:r>
            <a:r>
              <a:rPr lang="en-GB" sz="1200" i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GTP-bound Rap1 represses p120RasGAP leading to Ras activation (42), promoting tumour growth, cell motility and invasion.  Rap1 also activates </a:t>
            </a:r>
            <a:r>
              <a:rPr lang="en-GB" sz="1200" dirty="0" err="1">
                <a:latin typeface="Arial Nova" panose="020B0504020202020204" pitchFamily="34" charset="0"/>
              </a:rPr>
              <a:t>Rac</a:t>
            </a:r>
            <a:r>
              <a:rPr lang="en-GB" sz="1200" dirty="0">
                <a:latin typeface="Arial Nova" panose="020B0504020202020204" pitchFamily="34" charset="0"/>
              </a:rPr>
              <a:t> and Rho. Disruption of the GAP activity of PlexinB1 would allow Rap in its active GTP bound form to promote Ras, Rho and </a:t>
            </a:r>
            <a:r>
              <a:rPr lang="en-GB" sz="1200" dirty="0" err="1">
                <a:latin typeface="Arial Nova" panose="020B0504020202020204" pitchFamily="34" charset="0"/>
              </a:rPr>
              <a:t>Rac</a:t>
            </a:r>
            <a:r>
              <a:rPr lang="en-GB" sz="1200" dirty="0">
                <a:latin typeface="Arial Nova" panose="020B0504020202020204" pitchFamily="34" charset="0"/>
              </a:rPr>
              <a:t> activation, leading to the increase in MLC2 phosphorylation, invasion and metastasis observed. </a:t>
            </a:r>
            <a:r>
              <a:rPr lang="en-GB" sz="1200" i="1" dirty="0">
                <a:latin typeface="Arial Nova" panose="020B0504020202020204" pitchFamily="34" charset="0"/>
              </a:rPr>
              <a:t>PlexinB1 </a:t>
            </a:r>
            <a:r>
              <a:rPr lang="en-GB" sz="1200" i="1" baseline="30000" dirty="0">
                <a:latin typeface="Arial Nova" panose="020B0504020202020204" pitchFamily="34" charset="0"/>
              </a:rPr>
              <a:t>P1597L</a:t>
            </a:r>
            <a:r>
              <a:rPr lang="en-GB" sz="1200" i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may also activate </a:t>
            </a:r>
            <a:r>
              <a:rPr lang="en-GB" sz="1200" dirty="0" err="1">
                <a:latin typeface="Arial Nova" panose="020B0504020202020204" pitchFamily="34" charset="0"/>
              </a:rPr>
              <a:t>PDZRhoGEF</a:t>
            </a:r>
            <a:r>
              <a:rPr lang="en-GB" sz="1200" dirty="0">
                <a:latin typeface="Arial Nova" panose="020B0504020202020204" pitchFamily="34" charset="0"/>
              </a:rPr>
              <a:t>, promoting the conversion of </a:t>
            </a:r>
            <a:r>
              <a:rPr lang="en-GB" sz="1200" dirty="0" err="1">
                <a:latin typeface="Arial Nova" panose="020B0504020202020204" pitchFamily="34" charset="0"/>
              </a:rPr>
              <a:t>RhoA</a:t>
            </a:r>
            <a:r>
              <a:rPr lang="en-GB" sz="1200" dirty="0">
                <a:latin typeface="Arial Nova" panose="020B0504020202020204" pitchFamily="34" charset="0"/>
              </a:rPr>
              <a:t>-GDP to GTP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E7E1216-85E2-CC0C-3E7F-DEE556F25948}"/>
              </a:ext>
            </a:extLst>
          </p:cNvPr>
          <p:cNvGrpSpPr/>
          <p:nvPr/>
        </p:nvGrpSpPr>
        <p:grpSpPr>
          <a:xfrm>
            <a:off x="3568341" y="157886"/>
            <a:ext cx="3884440" cy="2522562"/>
            <a:chOff x="3568341" y="157886"/>
            <a:chExt cx="3884440" cy="2522562"/>
          </a:xfrm>
        </p:grpSpPr>
        <p:sp>
          <p:nvSpPr>
            <p:cNvPr id="396" name="Freeform: Shape 395">
              <a:extLst>
                <a:ext uri="{FF2B5EF4-FFF2-40B4-BE49-F238E27FC236}">
                  <a16:creationId xmlns:a16="http://schemas.microsoft.com/office/drawing/2014/main" id="{0E77148C-65CE-458F-AAA1-6FE22AF023FC}"/>
                </a:ext>
              </a:extLst>
            </p:cNvPr>
            <p:cNvSpPr/>
            <p:nvPr/>
          </p:nvSpPr>
          <p:spPr>
            <a:xfrm>
              <a:off x="4676137" y="1322431"/>
              <a:ext cx="1038644" cy="902282"/>
            </a:xfrm>
            <a:custGeom>
              <a:avLst/>
              <a:gdLst>
                <a:gd name="connsiteX0" fmla="*/ 703443 w 1147258"/>
                <a:gd name="connsiteY0" fmla="*/ 38100 h 1017633"/>
                <a:gd name="connsiteX1" fmla="*/ 1113018 w 1147258"/>
                <a:gd name="connsiteY1" fmla="*/ 266700 h 1017633"/>
                <a:gd name="connsiteX2" fmla="*/ 1103493 w 1147258"/>
                <a:gd name="connsiteY2" fmla="*/ 771525 h 1017633"/>
                <a:gd name="connsiteX3" fmla="*/ 932043 w 1147258"/>
                <a:gd name="connsiteY3" fmla="*/ 895350 h 1017633"/>
                <a:gd name="connsiteX4" fmla="*/ 589143 w 1147258"/>
                <a:gd name="connsiteY4" fmla="*/ 1000125 h 1017633"/>
                <a:gd name="connsiteX5" fmla="*/ 265293 w 1147258"/>
                <a:gd name="connsiteY5" fmla="*/ 1000125 h 1017633"/>
                <a:gd name="connsiteX6" fmla="*/ 17643 w 1147258"/>
                <a:gd name="connsiteY6" fmla="*/ 828675 h 1017633"/>
                <a:gd name="connsiteX7" fmla="*/ 27168 w 1147258"/>
                <a:gd name="connsiteY7" fmla="*/ 723900 h 1017633"/>
                <a:gd name="connsiteX8" fmla="*/ 84318 w 1147258"/>
                <a:gd name="connsiteY8" fmla="*/ 638175 h 1017633"/>
                <a:gd name="connsiteX9" fmla="*/ 227193 w 1147258"/>
                <a:gd name="connsiteY9" fmla="*/ 590550 h 1017633"/>
                <a:gd name="connsiteX10" fmla="*/ 303393 w 1147258"/>
                <a:gd name="connsiteY10" fmla="*/ 581025 h 1017633"/>
                <a:gd name="connsiteX11" fmla="*/ 455793 w 1147258"/>
                <a:gd name="connsiteY11" fmla="*/ 676275 h 1017633"/>
                <a:gd name="connsiteX12" fmla="*/ 608193 w 1147258"/>
                <a:gd name="connsiteY12" fmla="*/ 647700 h 1017633"/>
                <a:gd name="connsiteX13" fmla="*/ 760593 w 1147258"/>
                <a:gd name="connsiteY13" fmla="*/ 542925 h 1017633"/>
                <a:gd name="connsiteX14" fmla="*/ 827268 w 1147258"/>
                <a:gd name="connsiteY14" fmla="*/ 419100 h 1017633"/>
                <a:gd name="connsiteX15" fmla="*/ 712968 w 1147258"/>
                <a:gd name="connsiteY15" fmla="*/ 266700 h 1017633"/>
                <a:gd name="connsiteX16" fmla="*/ 589143 w 1147258"/>
                <a:gd name="connsiteY16" fmla="*/ 180975 h 1017633"/>
                <a:gd name="connsiteX17" fmla="*/ 541518 w 1147258"/>
                <a:gd name="connsiteY17" fmla="*/ 57150 h 1017633"/>
                <a:gd name="connsiteX18" fmla="*/ 655818 w 1147258"/>
                <a:gd name="connsiteY18" fmla="*/ 0 h 10176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147258" h="1017633">
                  <a:moveTo>
                    <a:pt x="703443" y="38100"/>
                  </a:moveTo>
                  <a:cubicBezTo>
                    <a:pt x="874893" y="91281"/>
                    <a:pt x="1046343" y="144463"/>
                    <a:pt x="1113018" y="266700"/>
                  </a:cubicBezTo>
                  <a:cubicBezTo>
                    <a:pt x="1179693" y="388938"/>
                    <a:pt x="1133655" y="666750"/>
                    <a:pt x="1103493" y="771525"/>
                  </a:cubicBezTo>
                  <a:cubicBezTo>
                    <a:pt x="1073331" y="876300"/>
                    <a:pt x="1017768" y="857250"/>
                    <a:pt x="932043" y="895350"/>
                  </a:cubicBezTo>
                  <a:cubicBezTo>
                    <a:pt x="846318" y="933450"/>
                    <a:pt x="700268" y="982663"/>
                    <a:pt x="589143" y="1000125"/>
                  </a:cubicBezTo>
                  <a:cubicBezTo>
                    <a:pt x="478018" y="1017588"/>
                    <a:pt x="360543" y="1028700"/>
                    <a:pt x="265293" y="1000125"/>
                  </a:cubicBezTo>
                  <a:cubicBezTo>
                    <a:pt x="170043" y="971550"/>
                    <a:pt x="57330" y="874712"/>
                    <a:pt x="17643" y="828675"/>
                  </a:cubicBezTo>
                  <a:cubicBezTo>
                    <a:pt x="-22044" y="782638"/>
                    <a:pt x="16056" y="755650"/>
                    <a:pt x="27168" y="723900"/>
                  </a:cubicBezTo>
                  <a:cubicBezTo>
                    <a:pt x="38280" y="692150"/>
                    <a:pt x="50981" y="660400"/>
                    <a:pt x="84318" y="638175"/>
                  </a:cubicBezTo>
                  <a:cubicBezTo>
                    <a:pt x="117655" y="615950"/>
                    <a:pt x="190681" y="600075"/>
                    <a:pt x="227193" y="590550"/>
                  </a:cubicBezTo>
                  <a:cubicBezTo>
                    <a:pt x="263705" y="581025"/>
                    <a:pt x="265293" y="566738"/>
                    <a:pt x="303393" y="581025"/>
                  </a:cubicBezTo>
                  <a:cubicBezTo>
                    <a:pt x="341493" y="595312"/>
                    <a:pt x="404993" y="665163"/>
                    <a:pt x="455793" y="676275"/>
                  </a:cubicBezTo>
                  <a:cubicBezTo>
                    <a:pt x="506593" y="687388"/>
                    <a:pt x="557393" y="669925"/>
                    <a:pt x="608193" y="647700"/>
                  </a:cubicBezTo>
                  <a:cubicBezTo>
                    <a:pt x="658993" y="625475"/>
                    <a:pt x="724081" y="581025"/>
                    <a:pt x="760593" y="542925"/>
                  </a:cubicBezTo>
                  <a:cubicBezTo>
                    <a:pt x="797105" y="504825"/>
                    <a:pt x="835205" y="465137"/>
                    <a:pt x="827268" y="419100"/>
                  </a:cubicBezTo>
                  <a:cubicBezTo>
                    <a:pt x="819331" y="373063"/>
                    <a:pt x="752655" y="306387"/>
                    <a:pt x="712968" y="266700"/>
                  </a:cubicBezTo>
                  <a:cubicBezTo>
                    <a:pt x="673281" y="227013"/>
                    <a:pt x="617718" y="215900"/>
                    <a:pt x="589143" y="180975"/>
                  </a:cubicBezTo>
                  <a:cubicBezTo>
                    <a:pt x="560568" y="146050"/>
                    <a:pt x="530406" y="87312"/>
                    <a:pt x="541518" y="57150"/>
                  </a:cubicBezTo>
                  <a:cubicBezTo>
                    <a:pt x="552630" y="26988"/>
                    <a:pt x="604224" y="13494"/>
                    <a:pt x="655818" y="0"/>
                  </a:cubicBezTo>
                </a:path>
              </a:pathLst>
            </a:custGeom>
            <a:solidFill>
              <a:srgbClr val="CCE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397" name="Oval 396">
              <a:extLst>
                <a:ext uri="{FF2B5EF4-FFF2-40B4-BE49-F238E27FC236}">
                  <a16:creationId xmlns:a16="http://schemas.microsoft.com/office/drawing/2014/main" id="{6954C61E-483E-42F4-844A-EAC9C48213B0}"/>
                </a:ext>
              </a:extLst>
            </p:cNvPr>
            <p:cNvSpPr/>
            <p:nvPr/>
          </p:nvSpPr>
          <p:spPr>
            <a:xfrm rot="2059538">
              <a:off x="5337025" y="1712037"/>
              <a:ext cx="377339" cy="453951"/>
            </a:xfrm>
            <a:prstGeom prst="ellipse">
              <a:avLst/>
            </a:prstGeom>
            <a:solidFill>
              <a:srgbClr val="E1F4FF"/>
            </a:solidFill>
            <a:ln>
              <a:solidFill>
                <a:srgbClr val="CCEC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398" name="Freeform: Shape 397">
              <a:extLst>
                <a:ext uri="{FF2B5EF4-FFF2-40B4-BE49-F238E27FC236}">
                  <a16:creationId xmlns:a16="http://schemas.microsoft.com/office/drawing/2014/main" id="{BF49D502-59F3-4F7E-ACDF-D7EFB59AB164}"/>
                </a:ext>
              </a:extLst>
            </p:cNvPr>
            <p:cNvSpPr/>
            <p:nvPr/>
          </p:nvSpPr>
          <p:spPr>
            <a:xfrm flipH="1">
              <a:off x="5830974" y="1362836"/>
              <a:ext cx="1038644" cy="902282"/>
            </a:xfrm>
            <a:custGeom>
              <a:avLst/>
              <a:gdLst>
                <a:gd name="connsiteX0" fmla="*/ 703443 w 1147258"/>
                <a:gd name="connsiteY0" fmla="*/ 38100 h 1017633"/>
                <a:gd name="connsiteX1" fmla="*/ 1113018 w 1147258"/>
                <a:gd name="connsiteY1" fmla="*/ 266700 h 1017633"/>
                <a:gd name="connsiteX2" fmla="*/ 1103493 w 1147258"/>
                <a:gd name="connsiteY2" fmla="*/ 771525 h 1017633"/>
                <a:gd name="connsiteX3" fmla="*/ 932043 w 1147258"/>
                <a:gd name="connsiteY3" fmla="*/ 895350 h 1017633"/>
                <a:gd name="connsiteX4" fmla="*/ 589143 w 1147258"/>
                <a:gd name="connsiteY4" fmla="*/ 1000125 h 1017633"/>
                <a:gd name="connsiteX5" fmla="*/ 265293 w 1147258"/>
                <a:gd name="connsiteY5" fmla="*/ 1000125 h 1017633"/>
                <a:gd name="connsiteX6" fmla="*/ 17643 w 1147258"/>
                <a:gd name="connsiteY6" fmla="*/ 828675 h 1017633"/>
                <a:gd name="connsiteX7" fmla="*/ 27168 w 1147258"/>
                <a:gd name="connsiteY7" fmla="*/ 723900 h 1017633"/>
                <a:gd name="connsiteX8" fmla="*/ 84318 w 1147258"/>
                <a:gd name="connsiteY8" fmla="*/ 638175 h 1017633"/>
                <a:gd name="connsiteX9" fmla="*/ 227193 w 1147258"/>
                <a:gd name="connsiteY9" fmla="*/ 590550 h 1017633"/>
                <a:gd name="connsiteX10" fmla="*/ 303393 w 1147258"/>
                <a:gd name="connsiteY10" fmla="*/ 581025 h 1017633"/>
                <a:gd name="connsiteX11" fmla="*/ 455793 w 1147258"/>
                <a:gd name="connsiteY11" fmla="*/ 676275 h 1017633"/>
                <a:gd name="connsiteX12" fmla="*/ 608193 w 1147258"/>
                <a:gd name="connsiteY12" fmla="*/ 647700 h 1017633"/>
                <a:gd name="connsiteX13" fmla="*/ 760593 w 1147258"/>
                <a:gd name="connsiteY13" fmla="*/ 542925 h 1017633"/>
                <a:gd name="connsiteX14" fmla="*/ 827268 w 1147258"/>
                <a:gd name="connsiteY14" fmla="*/ 419100 h 1017633"/>
                <a:gd name="connsiteX15" fmla="*/ 712968 w 1147258"/>
                <a:gd name="connsiteY15" fmla="*/ 266700 h 1017633"/>
                <a:gd name="connsiteX16" fmla="*/ 589143 w 1147258"/>
                <a:gd name="connsiteY16" fmla="*/ 180975 h 1017633"/>
                <a:gd name="connsiteX17" fmla="*/ 541518 w 1147258"/>
                <a:gd name="connsiteY17" fmla="*/ 57150 h 1017633"/>
                <a:gd name="connsiteX18" fmla="*/ 655818 w 1147258"/>
                <a:gd name="connsiteY18" fmla="*/ 0 h 10176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147258" h="1017633">
                  <a:moveTo>
                    <a:pt x="703443" y="38100"/>
                  </a:moveTo>
                  <a:cubicBezTo>
                    <a:pt x="874893" y="91281"/>
                    <a:pt x="1046343" y="144463"/>
                    <a:pt x="1113018" y="266700"/>
                  </a:cubicBezTo>
                  <a:cubicBezTo>
                    <a:pt x="1179693" y="388938"/>
                    <a:pt x="1133655" y="666750"/>
                    <a:pt x="1103493" y="771525"/>
                  </a:cubicBezTo>
                  <a:cubicBezTo>
                    <a:pt x="1073331" y="876300"/>
                    <a:pt x="1017768" y="857250"/>
                    <a:pt x="932043" y="895350"/>
                  </a:cubicBezTo>
                  <a:cubicBezTo>
                    <a:pt x="846318" y="933450"/>
                    <a:pt x="700268" y="982663"/>
                    <a:pt x="589143" y="1000125"/>
                  </a:cubicBezTo>
                  <a:cubicBezTo>
                    <a:pt x="478018" y="1017588"/>
                    <a:pt x="360543" y="1028700"/>
                    <a:pt x="265293" y="1000125"/>
                  </a:cubicBezTo>
                  <a:cubicBezTo>
                    <a:pt x="170043" y="971550"/>
                    <a:pt x="57330" y="874712"/>
                    <a:pt x="17643" y="828675"/>
                  </a:cubicBezTo>
                  <a:cubicBezTo>
                    <a:pt x="-22044" y="782638"/>
                    <a:pt x="16056" y="755650"/>
                    <a:pt x="27168" y="723900"/>
                  </a:cubicBezTo>
                  <a:cubicBezTo>
                    <a:pt x="38280" y="692150"/>
                    <a:pt x="50981" y="660400"/>
                    <a:pt x="84318" y="638175"/>
                  </a:cubicBezTo>
                  <a:cubicBezTo>
                    <a:pt x="117655" y="615950"/>
                    <a:pt x="190681" y="600075"/>
                    <a:pt x="227193" y="590550"/>
                  </a:cubicBezTo>
                  <a:cubicBezTo>
                    <a:pt x="263705" y="581025"/>
                    <a:pt x="265293" y="566738"/>
                    <a:pt x="303393" y="581025"/>
                  </a:cubicBezTo>
                  <a:cubicBezTo>
                    <a:pt x="341493" y="595312"/>
                    <a:pt x="404993" y="665163"/>
                    <a:pt x="455793" y="676275"/>
                  </a:cubicBezTo>
                  <a:cubicBezTo>
                    <a:pt x="506593" y="687388"/>
                    <a:pt x="557393" y="669925"/>
                    <a:pt x="608193" y="647700"/>
                  </a:cubicBezTo>
                  <a:cubicBezTo>
                    <a:pt x="658993" y="625475"/>
                    <a:pt x="724081" y="581025"/>
                    <a:pt x="760593" y="542925"/>
                  </a:cubicBezTo>
                  <a:cubicBezTo>
                    <a:pt x="797105" y="504825"/>
                    <a:pt x="835205" y="465137"/>
                    <a:pt x="827268" y="419100"/>
                  </a:cubicBezTo>
                  <a:cubicBezTo>
                    <a:pt x="819331" y="373063"/>
                    <a:pt x="752655" y="306387"/>
                    <a:pt x="712968" y="266700"/>
                  </a:cubicBezTo>
                  <a:cubicBezTo>
                    <a:pt x="673281" y="227013"/>
                    <a:pt x="617718" y="215900"/>
                    <a:pt x="589143" y="180975"/>
                  </a:cubicBezTo>
                  <a:cubicBezTo>
                    <a:pt x="560568" y="146050"/>
                    <a:pt x="530406" y="87312"/>
                    <a:pt x="541518" y="57150"/>
                  </a:cubicBezTo>
                  <a:cubicBezTo>
                    <a:pt x="552630" y="26988"/>
                    <a:pt x="604224" y="13494"/>
                    <a:pt x="655818" y="0"/>
                  </a:cubicBezTo>
                </a:path>
              </a:pathLst>
            </a:custGeom>
            <a:solidFill>
              <a:srgbClr val="CCE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399" name="Oval 398">
              <a:extLst>
                <a:ext uri="{FF2B5EF4-FFF2-40B4-BE49-F238E27FC236}">
                  <a16:creationId xmlns:a16="http://schemas.microsoft.com/office/drawing/2014/main" id="{268A6749-AB25-4CD7-9E8C-F79192ADEAF0}"/>
                </a:ext>
              </a:extLst>
            </p:cNvPr>
            <p:cNvSpPr/>
            <p:nvPr/>
          </p:nvSpPr>
          <p:spPr>
            <a:xfrm rot="19540462" flipH="1">
              <a:off x="5824568" y="1737315"/>
              <a:ext cx="377339" cy="453951"/>
            </a:xfrm>
            <a:prstGeom prst="ellipse">
              <a:avLst/>
            </a:prstGeom>
            <a:solidFill>
              <a:srgbClr val="E1F4FF"/>
            </a:solidFill>
            <a:ln>
              <a:solidFill>
                <a:srgbClr val="CCEC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latin typeface="Arial Nova" panose="020B0504020202020204" pitchFamily="34" charset="0"/>
              </a:endParaRPr>
            </a:p>
          </p:txBody>
        </p:sp>
        <p:sp>
          <p:nvSpPr>
            <p:cNvPr id="400" name="Rectangle 399">
              <a:extLst>
                <a:ext uri="{FF2B5EF4-FFF2-40B4-BE49-F238E27FC236}">
                  <a16:creationId xmlns:a16="http://schemas.microsoft.com/office/drawing/2014/main" id="{05CA2D06-D9F0-4603-9078-3091F94AB0FA}"/>
                </a:ext>
              </a:extLst>
            </p:cNvPr>
            <p:cNvSpPr/>
            <p:nvPr/>
          </p:nvSpPr>
          <p:spPr>
            <a:xfrm>
              <a:off x="5661685" y="435672"/>
              <a:ext cx="75074" cy="1253606"/>
            </a:xfrm>
            <a:prstGeom prst="rect">
              <a:avLst/>
            </a:prstGeom>
            <a:solidFill>
              <a:srgbClr val="CCE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401" name="Rectangle 400">
              <a:extLst>
                <a:ext uri="{FF2B5EF4-FFF2-40B4-BE49-F238E27FC236}">
                  <a16:creationId xmlns:a16="http://schemas.microsoft.com/office/drawing/2014/main" id="{62632BAD-6DE9-44C7-B7E4-D04EE9ADE039}"/>
                </a:ext>
              </a:extLst>
            </p:cNvPr>
            <p:cNvSpPr/>
            <p:nvPr/>
          </p:nvSpPr>
          <p:spPr>
            <a:xfrm>
              <a:off x="5827696" y="435672"/>
              <a:ext cx="75074" cy="1253606"/>
            </a:xfrm>
            <a:prstGeom prst="rect">
              <a:avLst/>
            </a:prstGeom>
            <a:solidFill>
              <a:srgbClr val="CCE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CBB21E0-B74B-6807-A097-FC0B868EDD3F}"/>
                </a:ext>
              </a:extLst>
            </p:cNvPr>
            <p:cNvGrpSpPr/>
            <p:nvPr/>
          </p:nvGrpSpPr>
          <p:grpSpPr>
            <a:xfrm>
              <a:off x="3568341" y="1598528"/>
              <a:ext cx="1716445" cy="1081920"/>
              <a:chOff x="630298" y="3402276"/>
              <a:chExt cx="1895938" cy="1220236"/>
            </a:xfrm>
          </p:grpSpPr>
          <p:sp>
            <p:nvSpPr>
              <p:cNvPr id="404" name="Freeform 10">
                <a:extLst>
                  <a:ext uri="{FF2B5EF4-FFF2-40B4-BE49-F238E27FC236}">
                    <a16:creationId xmlns:a16="http://schemas.microsoft.com/office/drawing/2014/main" id="{BE9F0039-7A01-40E5-8EBC-BF1FAAE07978}"/>
                  </a:ext>
                </a:extLst>
              </p:cNvPr>
              <p:cNvSpPr/>
              <p:nvPr/>
            </p:nvSpPr>
            <p:spPr>
              <a:xfrm rot="7436320">
                <a:off x="1406917" y="3660710"/>
                <a:ext cx="245416" cy="308611"/>
              </a:xfrm>
              <a:custGeom>
                <a:avLst/>
                <a:gdLst>
                  <a:gd name="connsiteX0" fmla="*/ 480405 w 600326"/>
                  <a:gd name="connsiteY0" fmla="*/ 0 h 1019331"/>
                  <a:gd name="connsiteX1" fmla="*/ 45690 w 600326"/>
                  <a:gd name="connsiteY1" fmla="*/ 389744 h 1019331"/>
                  <a:gd name="connsiteX2" fmla="*/ 75670 w 600326"/>
                  <a:gd name="connsiteY2" fmla="*/ 809469 h 1019331"/>
                  <a:gd name="connsiteX3" fmla="*/ 600326 w 600326"/>
                  <a:gd name="connsiteY3" fmla="*/ 1019331 h 1019331"/>
                  <a:gd name="connsiteX4" fmla="*/ 600326 w 600326"/>
                  <a:gd name="connsiteY4" fmla="*/ 1019331 h 10193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00326" h="1019331">
                    <a:moveTo>
                      <a:pt x="480405" y="0"/>
                    </a:moveTo>
                    <a:cubicBezTo>
                      <a:pt x="296775" y="127416"/>
                      <a:pt x="113146" y="254833"/>
                      <a:pt x="45690" y="389744"/>
                    </a:cubicBezTo>
                    <a:cubicBezTo>
                      <a:pt x="-21766" y="524656"/>
                      <a:pt x="-16769" y="704538"/>
                      <a:pt x="75670" y="809469"/>
                    </a:cubicBezTo>
                    <a:cubicBezTo>
                      <a:pt x="168109" y="914400"/>
                      <a:pt x="600326" y="1019331"/>
                      <a:pt x="600326" y="1019331"/>
                    </a:cubicBezTo>
                    <a:lnTo>
                      <a:pt x="600326" y="1019331"/>
                    </a:lnTo>
                  </a:path>
                </a:pathLst>
              </a:custGeom>
              <a:noFill/>
              <a:ln w="19050">
                <a:solidFill>
                  <a:schemeClr val="bg2">
                    <a:lumMod val="50000"/>
                  </a:schemeClr>
                </a:solidFill>
                <a:headEnd type="arrow" w="med" len="med"/>
                <a:tailEnd type="none" w="med" len="med"/>
              </a:ln>
              <a:scene3d>
                <a:camera prst="orthographicFront"/>
                <a:lightRig rig="threePt" dir="t"/>
              </a:scene3d>
              <a:sp3d prstMaterial="matte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405" name="Group 404">
                <a:extLst>
                  <a:ext uri="{FF2B5EF4-FFF2-40B4-BE49-F238E27FC236}">
                    <a16:creationId xmlns:a16="http://schemas.microsoft.com/office/drawing/2014/main" id="{D2719EA2-C70C-46EA-AE00-1C8863FFCC2B}"/>
                  </a:ext>
                </a:extLst>
              </p:cNvPr>
              <p:cNvGrpSpPr/>
              <p:nvPr/>
            </p:nvGrpSpPr>
            <p:grpSpPr>
              <a:xfrm>
                <a:off x="1312753" y="3402276"/>
                <a:ext cx="993679" cy="277699"/>
                <a:chOff x="3400022" y="3061472"/>
                <a:chExt cx="1026039" cy="331992"/>
              </a:xfrm>
              <a:noFill/>
            </p:grpSpPr>
            <p:sp>
              <p:nvSpPr>
                <p:cNvPr id="424" name="Rectangle 423">
                  <a:extLst>
                    <a:ext uri="{FF2B5EF4-FFF2-40B4-BE49-F238E27FC236}">
                      <a16:creationId xmlns:a16="http://schemas.microsoft.com/office/drawing/2014/main" id="{8BA14290-ED45-49B5-BBCD-0BE53F13B885}"/>
                    </a:ext>
                  </a:extLst>
                </p:cNvPr>
                <p:cNvSpPr/>
                <p:nvPr/>
              </p:nvSpPr>
              <p:spPr>
                <a:xfrm>
                  <a:off x="3482997" y="3132308"/>
                  <a:ext cx="775806" cy="16282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425" name="TextBox 424">
                  <a:extLst>
                    <a:ext uri="{FF2B5EF4-FFF2-40B4-BE49-F238E27FC236}">
                      <a16:creationId xmlns:a16="http://schemas.microsoft.com/office/drawing/2014/main" id="{A6417A42-341D-41D9-BB11-48001E3985D3}"/>
                    </a:ext>
                  </a:extLst>
                </p:cNvPr>
                <p:cNvSpPr txBox="1"/>
                <p:nvPr/>
              </p:nvSpPr>
              <p:spPr>
                <a:xfrm>
                  <a:off x="3400022" y="3061472"/>
                  <a:ext cx="1026039" cy="331992"/>
                </a:xfrm>
                <a:prstGeom prst="rect">
                  <a:avLst/>
                </a:prstGeom>
                <a:grpFill/>
                <a:ln>
                  <a:noFill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latin typeface="Arial Nova" panose="020B0504020202020204" pitchFamily="34" charset="0"/>
                    </a:rPr>
                    <a:t>PDZRhoGEF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406" name="Group 405">
                <a:extLst>
                  <a:ext uri="{FF2B5EF4-FFF2-40B4-BE49-F238E27FC236}">
                    <a16:creationId xmlns:a16="http://schemas.microsoft.com/office/drawing/2014/main" id="{AF86C83D-66C7-4ADD-85D0-EE045C2B0111}"/>
                  </a:ext>
                </a:extLst>
              </p:cNvPr>
              <p:cNvGrpSpPr/>
              <p:nvPr/>
            </p:nvGrpSpPr>
            <p:grpSpPr>
              <a:xfrm>
                <a:off x="1365419" y="3902392"/>
                <a:ext cx="1160817" cy="342318"/>
                <a:chOff x="1260139" y="3526377"/>
                <a:chExt cx="1160817" cy="342318"/>
              </a:xfrm>
            </p:grpSpPr>
            <p:sp>
              <p:nvSpPr>
                <p:cNvPr id="421" name="Rectangle 420">
                  <a:extLst>
                    <a:ext uri="{FF2B5EF4-FFF2-40B4-BE49-F238E27FC236}">
                      <a16:creationId xmlns:a16="http://schemas.microsoft.com/office/drawing/2014/main" id="{0F0977FD-93CA-4B0F-8504-2B04A1DB3B7F}"/>
                    </a:ext>
                  </a:extLst>
                </p:cNvPr>
                <p:cNvSpPr/>
                <p:nvPr/>
              </p:nvSpPr>
              <p:spPr>
                <a:xfrm rot="16200000">
                  <a:off x="1471999" y="3448695"/>
                  <a:ext cx="276998" cy="563002"/>
                </a:xfrm>
                <a:prstGeom prst="rect">
                  <a:avLst/>
                </a:prstGeom>
                <a:noFill/>
                <a:ln w="285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422" name="Rectangle 421">
                  <a:extLst>
                    <a:ext uri="{FF2B5EF4-FFF2-40B4-BE49-F238E27FC236}">
                      <a16:creationId xmlns:a16="http://schemas.microsoft.com/office/drawing/2014/main" id="{5E51E39F-E814-47AC-815B-F8AF1C8970E4}"/>
                    </a:ext>
                  </a:extLst>
                </p:cNvPr>
                <p:cNvSpPr/>
                <p:nvPr/>
              </p:nvSpPr>
              <p:spPr>
                <a:xfrm>
                  <a:off x="1346269" y="3602557"/>
                  <a:ext cx="574509" cy="19903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423" name="TextBox 422">
                  <a:extLst>
                    <a:ext uri="{FF2B5EF4-FFF2-40B4-BE49-F238E27FC236}">
                      <a16:creationId xmlns:a16="http://schemas.microsoft.com/office/drawing/2014/main" id="{3897A606-8DED-4674-88B0-799354B4A1A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260139" y="3526377"/>
                  <a:ext cx="1160817" cy="277698"/>
                </a:xfrm>
                <a:prstGeom prst="rect">
                  <a:avLst/>
                </a:prstGeom>
                <a:noFill/>
                <a:ln>
                  <a:noFill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r>
                    <a:rPr lang="en-GB" altLang="en-US" sz="1000" dirty="0" err="1">
                      <a:latin typeface="Arial Nova" panose="020B0504020202020204" pitchFamily="34" charset="0"/>
                    </a:rPr>
                    <a:t>RhoGTP</a:t>
                  </a:r>
                  <a:endParaRPr lang="en-GB" altLang="en-US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407" name="Group 406">
                <a:extLst>
                  <a:ext uri="{FF2B5EF4-FFF2-40B4-BE49-F238E27FC236}">
                    <a16:creationId xmlns:a16="http://schemas.microsoft.com/office/drawing/2014/main" id="{3B88D830-6283-40B6-B8E7-6C4BC862C366}"/>
                  </a:ext>
                </a:extLst>
              </p:cNvPr>
              <p:cNvGrpSpPr/>
              <p:nvPr/>
            </p:nvGrpSpPr>
            <p:grpSpPr>
              <a:xfrm>
                <a:off x="1098403" y="4344814"/>
                <a:ext cx="1053879" cy="277698"/>
                <a:chOff x="3000921" y="3170896"/>
                <a:chExt cx="1129309" cy="331992"/>
              </a:xfrm>
              <a:noFill/>
            </p:grpSpPr>
            <p:sp>
              <p:nvSpPr>
                <p:cNvPr id="419" name="Rectangle 418">
                  <a:extLst>
                    <a:ext uri="{FF2B5EF4-FFF2-40B4-BE49-F238E27FC236}">
                      <a16:creationId xmlns:a16="http://schemas.microsoft.com/office/drawing/2014/main" id="{9EACB8A8-1C2F-47CE-97C3-9B52AC0061E3}"/>
                    </a:ext>
                  </a:extLst>
                </p:cNvPr>
                <p:cNvSpPr/>
                <p:nvPr/>
              </p:nvSpPr>
              <p:spPr>
                <a:xfrm>
                  <a:off x="3093516" y="3294583"/>
                  <a:ext cx="933751" cy="202022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420" name="TextBox 419">
                  <a:extLst>
                    <a:ext uri="{FF2B5EF4-FFF2-40B4-BE49-F238E27FC236}">
                      <a16:creationId xmlns:a16="http://schemas.microsoft.com/office/drawing/2014/main" id="{E5E7B678-CB4F-497A-9648-7AA21CCEA147}"/>
                    </a:ext>
                  </a:extLst>
                </p:cNvPr>
                <p:cNvSpPr txBox="1"/>
                <p:nvPr/>
              </p:nvSpPr>
              <p:spPr>
                <a:xfrm>
                  <a:off x="3000921" y="3170896"/>
                  <a:ext cx="1129309" cy="331992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>
                      <a:latin typeface="Arial Nova" panose="020B0504020202020204" pitchFamily="34" charset="0"/>
                    </a:rPr>
                    <a:t>p190RhoGAP</a:t>
                  </a:r>
                </a:p>
              </p:txBody>
            </p:sp>
          </p:grpSp>
          <p:sp>
            <p:nvSpPr>
              <p:cNvPr id="418" name="Rectangle 417">
                <a:extLst>
                  <a:ext uri="{FF2B5EF4-FFF2-40B4-BE49-F238E27FC236}">
                    <a16:creationId xmlns:a16="http://schemas.microsoft.com/office/drawing/2014/main" id="{1047EED8-27A0-46F2-8507-9CC409CB58B7}"/>
                  </a:ext>
                </a:extLst>
              </p:cNvPr>
              <p:cNvSpPr/>
              <p:nvPr/>
            </p:nvSpPr>
            <p:spPr>
              <a:xfrm>
                <a:off x="709999" y="3913443"/>
                <a:ext cx="578927" cy="204076"/>
              </a:xfrm>
              <a:prstGeom prst="rect">
                <a:avLst/>
              </a:prstGeom>
              <a:solidFill>
                <a:srgbClr val="FFCC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415" name="TextBox 414">
                <a:extLst>
                  <a:ext uri="{FF2B5EF4-FFF2-40B4-BE49-F238E27FC236}">
                    <a16:creationId xmlns:a16="http://schemas.microsoft.com/office/drawing/2014/main" id="{7B68FB57-F79B-4F99-B86C-2A402D2DE62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44876" y="3736015"/>
                <a:ext cx="204049" cy="277699"/>
              </a:xfrm>
              <a:prstGeom prst="rect">
                <a:avLst/>
              </a:prstGeom>
              <a:noFill/>
              <a:ln>
                <a:noFill/>
              </a:ln>
              <a:scene3d>
                <a:camera prst="orthographicFront"/>
                <a:lightRig rig="threePt" dir="t"/>
              </a:scene3d>
              <a:sp3d prstMaterial="matte"/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endParaRPr lang="en-GB" altLang="en-US" sz="10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416" name="TextBox 415">
                <a:extLst>
                  <a:ext uri="{FF2B5EF4-FFF2-40B4-BE49-F238E27FC236}">
                    <a16:creationId xmlns:a16="http://schemas.microsoft.com/office/drawing/2014/main" id="{54F6A108-FAF1-4DDD-8261-8E65C303608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0298" y="3883815"/>
                <a:ext cx="744020" cy="277699"/>
              </a:xfrm>
              <a:prstGeom prst="rect">
                <a:avLst/>
              </a:prstGeom>
              <a:noFill/>
              <a:ln>
                <a:noFill/>
              </a:ln>
              <a:scene3d>
                <a:camera prst="orthographicFront"/>
                <a:lightRig rig="threePt" dir="t"/>
              </a:scene3d>
              <a:sp3d prstMaterial="matte"/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en-GB" altLang="en-US" sz="1000" dirty="0" err="1">
                    <a:latin typeface="Arial Nova" panose="020B0504020202020204" pitchFamily="34" charset="0"/>
                  </a:rPr>
                  <a:t>RhoGDP</a:t>
                </a:r>
                <a:endParaRPr lang="en-GB" altLang="en-US" sz="10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409" name="Freeform 10">
                <a:extLst>
                  <a:ext uri="{FF2B5EF4-FFF2-40B4-BE49-F238E27FC236}">
                    <a16:creationId xmlns:a16="http://schemas.microsoft.com/office/drawing/2014/main" id="{9D46AA26-6ADF-4D1E-9D58-98844EA53CD3}"/>
                  </a:ext>
                </a:extLst>
              </p:cNvPr>
              <p:cNvSpPr/>
              <p:nvPr/>
            </p:nvSpPr>
            <p:spPr>
              <a:xfrm rot="18052700">
                <a:off x="1263577" y="4161828"/>
                <a:ext cx="176866" cy="274634"/>
              </a:xfrm>
              <a:custGeom>
                <a:avLst/>
                <a:gdLst>
                  <a:gd name="connsiteX0" fmla="*/ 480405 w 600326"/>
                  <a:gd name="connsiteY0" fmla="*/ 0 h 1019331"/>
                  <a:gd name="connsiteX1" fmla="*/ 45690 w 600326"/>
                  <a:gd name="connsiteY1" fmla="*/ 389744 h 1019331"/>
                  <a:gd name="connsiteX2" fmla="*/ 75670 w 600326"/>
                  <a:gd name="connsiteY2" fmla="*/ 809469 h 1019331"/>
                  <a:gd name="connsiteX3" fmla="*/ 600326 w 600326"/>
                  <a:gd name="connsiteY3" fmla="*/ 1019331 h 1019331"/>
                  <a:gd name="connsiteX4" fmla="*/ 600326 w 600326"/>
                  <a:gd name="connsiteY4" fmla="*/ 1019331 h 10193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00326" h="1019331">
                    <a:moveTo>
                      <a:pt x="480405" y="0"/>
                    </a:moveTo>
                    <a:cubicBezTo>
                      <a:pt x="296775" y="127416"/>
                      <a:pt x="113146" y="254833"/>
                      <a:pt x="45690" y="389744"/>
                    </a:cubicBezTo>
                    <a:cubicBezTo>
                      <a:pt x="-21766" y="524656"/>
                      <a:pt x="-16769" y="704538"/>
                      <a:pt x="75670" y="809469"/>
                    </a:cubicBezTo>
                    <a:cubicBezTo>
                      <a:pt x="168109" y="914400"/>
                      <a:pt x="600326" y="1019331"/>
                      <a:pt x="600326" y="1019331"/>
                    </a:cubicBezTo>
                    <a:lnTo>
                      <a:pt x="600326" y="1019331"/>
                    </a:lnTo>
                  </a:path>
                </a:pathLst>
              </a:custGeom>
              <a:noFill/>
              <a:ln w="19050">
                <a:solidFill>
                  <a:schemeClr val="bg2">
                    <a:lumMod val="50000"/>
                  </a:schemeClr>
                </a:solidFill>
                <a:headEnd type="arrow" w="med" len="med"/>
                <a:tailEnd type="none" w="med" len="med"/>
              </a:ln>
              <a:scene3d>
                <a:camera prst="orthographicFront"/>
                <a:lightRig rig="threePt" dir="t"/>
              </a:scene3d>
              <a:sp3d prstMaterial="matte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</p:grpSp>
        <p:sp>
          <p:nvSpPr>
            <p:cNvPr id="429" name="Freeform 23">
              <a:extLst>
                <a:ext uri="{FF2B5EF4-FFF2-40B4-BE49-F238E27FC236}">
                  <a16:creationId xmlns:a16="http://schemas.microsoft.com/office/drawing/2014/main" id="{DB2B8DBD-EAFF-4ECC-8A87-239E1F661BEA}"/>
                </a:ext>
              </a:extLst>
            </p:cNvPr>
            <p:cNvSpPr/>
            <p:nvPr/>
          </p:nvSpPr>
          <p:spPr>
            <a:xfrm rot="20076041">
              <a:off x="6202452" y="1524665"/>
              <a:ext cx="396449" cy="385799"/>
            </a:xfrm>
            <a:custGeom>
              <a:avLst/>
              <a:gdLst>
                <a:gd name="connsiteX0" fmla="*/ 480405 w 600326"/>
                <a:gd name="connsiteY0" fmla="*/ 0 h 1019331"/>
                <a:gd name="connsiteX1" fmla="*/ 45690 w 600326"/>
                <a:gd name="connsiteY1" fmla="*/ 389744 h 1019331"/>
                <a:gd name="connsiteX2" fmla="*/ 75670 w 600326"/>
                <a:gd name="connsiteY2" fmla="*/ 809469 h 1019331"/>
                <a:gd name="connsiteX3" fmla="*/ 600326 w 600326"/>
                <a:gd name="connsiteY3" fmla="*/ 1019331 h 1019331"/>
                <a:gd name="connsiteX4" fmla="*/ 600326 w 600326"/>
                <a:gd name="connsiteY4" fmla="*/ 1019331 h 10193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00326" h="1019331">
                  <a:moveTo>
                    <a:pt x="480405" y="0"/>
                  </a:moveTo>
                  <a:cubicBezTo>
                    <a:pt x="296775" y="127416"/>
                    <a:pt x="113146" y="254833"/>
                    <a:pt x="45690" y="389744"/>
                  </a:cubicBezTo>
                  <a:cubicBezTo>
                    <a:pt x="-21766" y="524656"/>
                    <a:pt x="-16769" y="704538"/>
                    <a:pt x="75670" y="809469"/>
                  </a:cubicBezTo>
                  <a:cubicBezTo>
                    <a:pt x="168109" y="914400"/>
                    <a:pt x="600326" y="1019331"/>
                    <a:pt x="600326" y="1019331"/>
                  </a:cubicBezTo>
                  <a:lnTo>
                    <a:pt x="600326" y="1019331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olid"/>
              <a:headEnd type="none" w="med" len="med"/>
              <a:tailEnd type="arrow" w="med" len="med"/>
            </a:ln>
            <a:scene3d>
              <a:camera prst="orthographicFront"/>
              <a:lightRig rig="threePt" dir="t"/>
            </a:scene3d>
            <a:sp3d prstMaterial="matte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latin typeface="Arial Nova" panose="020B0504020202020204" pitchFamily="34" charset="0"/>
              </a:endParaRPr>
            </a:p>
          </p:txBody>
        </p:sp>
        <p:grpSp>
          <p:nvGrpSpPr>
            <p:cNvPr id="477" name="Group 476">
              <a:extLst>
                <a:ext uri="{FF2B5EF4-FFF2-40B4-BE49-F238E27FC236}">
                  <a16:creationId xmlns:a16="http://schemas.microsoft.com/office/drawing/2014/main" id="{E26DA578-4722-4BD6-8113-A231255DCA94}"/>
                </a:ext>
              </a:extLst>
            </p:cNvPr>
            <p:cNvGrpSpPr/>
            <p:nvPr/>
          </p:nvGrpSpPr>
          <p:grpSpPr>
            <a:xfrm>
              <a:off x="6673120" y="1668686"/>
              <a:ext cx="712578" cy="246221"/>
              <a:chOff x="2238061" y="2649411"/>
              <a:chExt cx="634669" cy="256222"/>
            </a:xfrm>
          </p:grpSpPr>
          <p:grpSp>
            <p:nvGrpSpPr>
              <p:cNvPr id="478" name="Group 477">
                <a:extLst>
                  <a:ext uri="{FF2B5EF4-FFF2-40B4-BE49-F238E27FC236}">
                    <a16:creationId xmlns:a16="http://schemas.microsoft.com/office/drawing/2014/main" id="{EBA28B1A-93ED-4988-8072-77931E096098}"/>
                  </a:ext>
                </a:extLst>
              </p:cNvPr>
              <p:cNvGrpSpPr/>
              <p:nvPr/>
            </p:nvGrpSpPr>
            <p:grpSpPr>
              <a:xfrm>
                <a:off x="2238061" y="2649411"/>
                <a:ext cx="629290" cy="256222"/>
                <a:chOff x="2244287" y="2649411"/>
                <a:chExt cx="629290" cy="256222"/>
              </a:xfrm>
            </p:grpSpPr>
            <p:sp>
              <p:nvSpPr>
                <p:cNvPr id="480" name="Rectangle 479">
                  <a:extLst>
                    <a:ext uri="{FF2B5EF4-FFF2-40B4-BE49-F238E27FC236}">
                      <a16:creationId xmlns:a16="http://schemas.microsoft.com/office/drawing/2014/main" id="{46703AC9-0CDE-47D6-BC7C-EEC7D5159547}"/>
                    </a:ext>
                  </a:extLst>
                </p:cNvPr>
                <p:cNvSpPr/>
                <p:nvPr/>
              </p:nvSpPr>
              <p:spPr>
                <a:xfrm>
                  <a:off x="2294950" y="2700813"/>
                  <a:ext cx="578627" cy="191497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481" name="TextBox 480">
                  <a:extLst>
                    <a:ext uri="{FF2B5EF4-FFF2-40B4-BE49-F238E27FC236}">
                      <a16:creationId xmlns:a16="http://schemas.microsoft.com/office/drawing/2014/main" id="{AFB90990-A2B3-4ECB-9201-7AA77CF4D2F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244287" y="2649411"/>
                  <a:ext cx="599936" cy="256222"/>
                </a:xfrm>
                <a:prstGeom prst="rect">
                  <a:avLst/>
                </a:prstGeom>
                <a:noFill/>
                <a:ln>
                  <a:noFill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r>
                    <a:rPr lang="en-GB" altLang="en-US" sz="1000" dirty="0" err="1">
                      <a:latin typeface="Arial Nova" panose="020B0504020202020204" pitchFamily="34" charset="0"/>
                    </a:rPr>
                    <a:t>RapGDP</a:t>
                  </a:r>
                  <a:endParaRPr lang="en-GB" altLang="en-US" sz="1000" dirty="0">
                    <a:latin typeface="Arial Nova" panose="020B0504020202020204" pitchFamily="34" charset="0"/>
                  </a:endParaRPr>
                </a:p>
              </p:txBody>
            </p:sp>
          </p:grpSp>
          <p:sp>
            <p:nvSpPr>
              <p:cNvPr id="479" name="Rectangle 478">
                <a:extLst>
                  <a:ext uri="{FF2B5EF4-FFF2-40B4-BE49-F238E27FC236}">
                    <a16:creationId xmlns:a16="http://schemas.microsoft.com/office/drawing/2014/main" id="{CE711C92-1E00-4116-88A2-2339FC85B4F2}"/>
                  </a:ext>
                </a:extLst>
              </p:cNvPr>
              <p:cNvSpPr/>
              <p:nvPr/>
            </p:nvSpPr>
            <p:spPr>
              <a:xfrm rot="16200000">
                <a:off x="2459984" y="2492574"/>
                <a:ext cx="216826" cy="608667"/>
              </a:xfrm>
              <a:prstGeom prst="rect">
                <a:avLst/>
              </a:prstGeom>
              <a:noFill/>
              <a:ln w="285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grpSp>
          <p:nvGrpSpPr>
            <p:cNvPr id="488" name="Group 487">
              <a:extLst>
                <a:ext uri="{FF2B5EF4-FFF2-40B4-BE49-F238E27FC236}">
                  <a16:creationId xmlns:a16="http://schemas.microsoft.com/office/drawing/2014/main" id="{5A155137-C527-4B49-8FDC-988EBE58C7F7}"/>
                </a:ext>
              </a:extLst>
            </p:cNvPr>
            <p:cNvGrpSpPr/>
            <p:nvPr/>
          </p:nvGrpSpPr>
          <p:grpSpPr>
            <a:xfrm>
              <a:off x="6401861" y="1300018"/>
              <a:ext cx="1050920" cy="246221"/>
              <a:chOff x="1306291" y="3629173"/>
              <a:chExt cx="1160817" cy="212920"/>
            </a:xfrm>
          </p:grpSpPr>
          <p:sp>
            <p:nvSpPr>
              <p:cNvPr id="489" name="Rectangle 488">
                <a:extLst>
                  <a:ext uri="{FF2B5EF4-FFF2-40B4-BE49-F238E27FC236}">
                    <a16:creationId xmlns:a16="http://schemas.microsoft.com/office/drawing/2014/main" id="{AC23B649-2B1C-4646-8EB7-18C60C70A6DA}"/>
                  </a:ext>
                </a:extLst>
              </p:cNvPr>
              <p:cNvSpPr/>
              <p:nvPr/>
            </p:nvSpPr>
            <p:spPr>
              <a:xfrm rot="16200000">
                <a:off x="1527224" y="3439520"/>
                <a:ext cx="166547" cy="563002"/>
              </a:xfrm>
              <a:prstGeom prst="rect">
                <a:avLst/>
              </a:prstGeom>
              <a:noFill/>
              <a:ln w="285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491" name="TextBox 490">
                <a:extLst>
                  <a:ext uri="{FF2B5EF4-FFF2-40B4-BE49-F238E27FC236}">
                    <a16:creationId xmlns:a16="http://schemas.microsoft.com/office/drawing/2014/main" id="{89ED46BC-4F5E-4351-A8BD-6387BBDCA98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06291" y="3629173"/>
                <a:ext cx="1160817" cy="212920"/>
              </a:xfrm>
              <a:prstGeom prst="rect">
                <a:avLst/>
              </a:prstGeom>
              <a:noFill/>
              <a:ln>
                <a:noFill/>
              </a:ln>
              <a:scene3d>
                <a:camera prst="orthographicFront"/>
                <a:lightRig rig="threePt" dir="t"/>
              </a:scene3d>
              <a:sp3d prstMaterial="matte"/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en-GB" altLang="en-US" sz="1000" dirty="0" err="1">
                    <a:solidFill>
                      <a:schemeClr val="bg1">
                        <a:lumMod val="65000"/>
                      </a:schemeClr>
                    </a:solidFill>
                    <a:latin typeface="Arial Nova" panose="020B0504020202020204" pitchFamily="34" charset="0"/>
                  </a:rPr>
                  <a:t>RapGTP</a:t>
                </a:r>
                <a:endParaRPr lang="en-GB" altLang="en-US" sz="1000" dirty="0">
                  <a:solidFill>
                    <a:schemeClr val="bg1">
                      <a:lumMod val="65000"/>
                    </a:schemeClr>
                  </a:solidFill>
                  <a:latin typeface="Arial Nova" panose="020B0504020202020204" pitchFamily="34" charset="0"/>
                </a:endParaRPr>
              </a:p>
            </p:txBody>
          </p:sp>
        </p:grpSp>
        <p:grpSp>
          <p:nvGrpSpPr>
            <p:cNvPr id="333" name="Group 332">
              <a:extLst>
                <a:ext uri="{FF2B5EF4-FFF2-40B4-BE49-F238E27FC236}">
                  <a16:creationId xmlns:a16="http://schemas.microsoft.com/office/drawing/2014/main" id="{6B08CAA6-CCFD-945A-1303-14AF871C1315}"/>
                </a:ext>
              </a:extLst>
            </p:cNvPr>
            <p:cNvGrpSpPr/>
            <p:nvPr/>
          </p:nvGrpSpPr>
          <p:grpSpPr>
            <a:xfrm>
              <a:off x="5688025" y="157886"/>
              <a:ext cx="187765" cy="700034"/>
              <a:chOff x="4879335" y="167302"/>
              <a:chExt cx="471665" cy="999836"/>
            </a:xfrm>
          </p:grpSpPr>
          <p:grpSp>
            <p:nvGrpSpPr>
              <p:cNvPr id="334" name="Group 333">
                <a:extLst>
                  <a:ext uri="{FF2B5EF4-FFF2-40B4-BE49-F238E27FC236}">
                    <a16:creationId xmlns:a16="http://schemas.microsoft.com/office/drawing/2014/main" id="{343084F4-4A37-ADFD-19FE-091E376AEAB8}"/>
                  </a:ext>
                </a:extLst>
              </p:cNvPr>
              <p:cNvGrpSpPr/>
              <p:nvPr/>
            </p:nvGrpSpPr>
            <p:grpSpPr>
              <a:xfrm>
                <a:off x="4879335" y="168197"/>
                <a:ext cx="339756" cy="998941"/>
                <a:chOff x="9335386" y="0"/>
                <a:chExt cx="339756" cy="998941"/>
              </a:xfrm>
            </p:grpSpPr>
            <p:sp>
              <p:nvSpPr>
                <p:cNvPr id="338" name="Oval 337">
                  <a:extLst>
                    <a:ext uri="{FF2B5EF4-FFF2-40B4-BE49-F238E27FC236}">
                      <a16:creationId xmlns:a16="http://schemas.microsoft.com/office/drawing/2014/main" id="{E03FA2EC-C2CD-7DD3-6587-A1AEE63FEB6B}"/>
                    </a:ext>
                  </a:extLst>
                </p:cNvPr>
                <p:cNvSpPr/>
                <p:nvPr/>
              </p:nvSpPr>
              <p:spPr>
                <a:xfrm>
                  <a:off x="9335386" y="347330"/>
                  <a:ext cx="339756" cy="651611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rgbClr val="FFC000">
                        <a:shade val="30000"/>
                        <a:satMod val="115000"/>
                      </a:srgbClr>
                    </a:gs>
                    <a:gs pos="50000">
                      <a:srgbClr val="FFC000">
                        <a:shade val="67500"/>
                        <a:satMod val="115000"/>
                      </a:srgbClr>
                    </a:gs>
                    <a:gs pos="100000">
                      <a:srgbClr val="FFC000">
                        <a:shade val="100000"/>
                        <a:satMod val="115000"/>
                      </a:srgbClr>
                    </a:gs>
                  </a:gsLst>
                  <a:lin ang="108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339" name="Rectangle 338">
                  <a:extLst>
                    <a:ext uri="{FF2B5EF4-FFF2-40B4-BE49-F238E27FC236}">
                      <a16:creationId xmlns:a16="http://schemas.microsoft.com/office/drawing/2014/main" id="{CCEE93C0-31C5-2C8C-76F2-E71E2F0BFE40}"/>
                    </a:ext>
                  </a:extLst>
                </p:cNvPr>
                <p:cNvSpPr/>
                <p:nvPr/>
              </p:nvSpPr>
              <p:spPr>
                <a:xfrm>
                  <a:off x="9448797" y="0"/>
                  <a:ext cx="97037" cy="465463"/>
                </a:xfrm>
                <a:prstGeom prst="rect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335" name="Group 334">
                <a:extLst>
                  <a:ext uri="{FF2B5EF4-FFF2-40B4-BE49-F238E27FC236}">
                    <a16:creationId xmlns:a16="http://schemas.microsoft.com/office/drawing/2014/main" id="{66344B35-AEA6-A6D2-13A0-3C956A6AAD03}"/>
                  </a:ext>
                </a:extLst>
              </p:cNvPr>
              <p:cNvGrpSpPr/>
              <p:nvPr/>
            </p:nvGrpSpPr>
            <p:grpSpPr>
              <a:xfrm>
                <a:off x="5011244" y="167302"/>
                <a:ext cx="339756" cy="998941"/>
                <a:chOff x="9335386" y="0"/>
                <a:chExt cx="339756" cy="998941"/>
              </a:xfrm>
            </p:grpSpPr>
            <p:sp>
              <p:nvSpPr>
                <p:cNvPr id="336" name="Oval 335">
                  <a:extLst>
                    <a:ext uri="{FF2B5EF4-FFF2-40B4-BE49-F238E27FC236}">
                      <a16:creationId xmlns:a16="http://schemas.microsoft.com/office/drawing/2014/main" id="{FE11FFF1-6C5F-5988-C8DA-131B7C455CF3}"/>
                    </a:ext>
                  </a:extLst>
                </p:cNvPr>
                <p:cNvSpPr/>
                <p:nvPr/>
              </p:nvSpPr>
              <p:spPr>
                <a:xfrm>
                  <a:off x="9335386" y="347330"/>
                  <a:ext cx="339756" cy="651611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rgbClr val="FFC000">
                        <a:shade val="30000"/>
                        <a:satMod val="115000"/>
                      </a:srgbClr>
                    </a:gs>
                    <a:gs pos="50000">
                      <a:srgbClr val="FFC000">
                        <a:shade val="67500"/>
                        <a:satMod val="115000"/>
                      </a:srgbClr>
                    </a:gs>
                    <a:gs pos="100000">
                      <a:srgbClr val="FFC000">
                        <a:shade val="100000"/>
                        <a:satMod val="115000"/>
                      </a:srgbClr>
                    </a:gs>
                  </a:gsLst>
                  <a:lin ang="108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337" name="Rectangle 336">
                  <a:extLst>
                    <a:ext uri="{FF2B5EF4-FFF2-40B4-BE49-F238E27FC236}">
                      <a16:creationId xmlns:a16="http://schemas.microsoft.com/office/drawing/2014/main" id="{BC80C2EF-738B-501B-B619-0317800DA1BC}"/>
                    </a:ext>
                  </a:extLst>
                </p:cNvPr>
                <p:cNvSpPr/>
                <p:nvPr/>
              </p:nvSpPr>
              <p:spPr>
                <a:xfrm>
                  <a:off x="9448797" y="0"/>
                  <a:ext cx="97037" cy="465463"/>
                </a:xfrm>
                <a:prstGeom prst="rect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</p:grpSp>
        </p:grp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9E9B257B-174A-700D-BA30-7F92BF7E7E1D}"/>
                </a:ext>
              </a:extLst>
            </p:cNvPr>
            <p:cNvSpPr txBox="1"/>
            <p:nvPr/>
          </p:nvSpPr>
          <p:spPr>
            <a:xfrm>
              <a:off x="5799806" y="214738"/>
              <a:ext cx="673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C000"/>
                  </a:solidFill>
                  <a:latin typeface="Arial Nova" panose="020B0504020202020204" pitchFamily="34" charset="0"/>
                </a:rPr>
                <a:t>Sema4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41A83BD-5D2E-7D13-904E-C3867943AFF8}"/>
                </a:ext>
              </a:extLst>
            </p:cNvPr>
            <p:cNvSpPr txBox="1"/>
            <p:nvPr/>
          </p:nvSpPr>
          <p:spPr>
            <a:xfrm>
              <a:off x="4087633" y="671938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A</a:t>
              </a:r>
            </a:p>
          </p:txBody>
        </p: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AC3785A4-64CF-42DA-BC0D-61C24C6A537F}"/>
                </a:ext>
              </a:extLst>
            </p:cNvPr>
            <p:cNvGrpSpPr/>
            <p:nvPr/>
          </p:nvGrpSpPr>
          <p:grpSpPr>
            <a:xfrm>
              <a:off x="5762241" y="1819870"/>
              <a:ext cx="414880" cy="362529"/>
              <a:chOff x="4221628" y="2531017"/>
              <a:chExt cx="458265" cy="419253"/>
            </a:xfrm>
          </p:grpSpPr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026247AC-B611-7D86-9106-F20C480719CB}"/>
                  </a:ext>
                </a:extLst>
              </p:cNvPr>
              <p:cNvGrpSpPr/>
              <p:nvPr/>
            </p:nvGrpSpPr>
            <p:grpSpPr>
              <a:xfrm>
                <a:off x="4235110" y="2531017"/>
                <a:ext cx="444783" cy="284746"/>
                <a:chOff x="6416383" y="7776959"/>
                <a:chExt cx="435769" cy="340419"/>
              </a:xfrm>
            </p:grpSpPr>
            <p:sp>
              <p:nvSpPr>
                <p:cNvPr id="145" name="Oval 144">
                  <a:extLst>
                    <a:ext uri="{FF2B5EF4-FFF2-40B4-BE49-F238E27FC236}">
                      <a16:creationId xmlns:a16="http://schemas.microsoft.com/office/drawing/2014/main" id="{8D733C81-3921-F587-776A-F00A66E0AB54}"/>
                    </a:ext>
                  </a:extLst>
                </p:cNvPr>
                <p:cNvSpPr/>
                <p:nvPr/>
              </p:nvSpPr>
              <p:spPr>
                <a:xfrm>
                  <a:off x="6475686" y="7867431"/>
                  <a:ext cx="288736" cy="179129"/>
                </a:xfrm>
                <a:prstGeom prst="ellipse">
                  <a:avLst/>
                </a:prstGeom>
                <a:solidFill>
                  <a:srgbClr val="CCFFFF"/>
                </a:solidFill>
                <a:ln w="1270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6E48BD5E-9563-F4BC-7CC1-4534D13F25FF}"/>
                    </a:ext>
                  </a:extLst>
                </p:cNvPr>
                <p:cNvSpPr txBox="1"/>
                <p:nvPr/>
              </p:nvSpPr>
              <p:spPr>
                <a:xfrm>
                  <a:off x="6416383" y="7776959"/>
                  <a:ext cx="435769" cy="3404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latin typeface="Arial Nova" panose="020B0504020202020204" pitchFamily="34" charset="0"/>
                    </a:rPr>
                    <a:t>Rac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E0205B14-2720-AA08-E5E8-6CCC1E23DE87}"/>
                  </a:ext>
                </a:extLst>
              </p:cNvPr>
              <p:cNvGrpSpPr/>
              <p:nvPr/>
            </p:nvGrpSpPr>
            <p:grpSpPr>
              <a:xfrm>
                <a:off x="4221628" y="2665523"/>
                <a:ext cx="455407" cy="284747"/>
                <a:chOff x="4731928" y="2657993"/>
                <a:chExt cx="455407" cy="284747"/>
              </a:xfrm>
            </p:grpSpPr>
            <p:sp>
              <p:nvSpPr>
                <p:cNvPr id="143" name="Oval 142">
                  <a:extLst>
                    <a:ext uri="{FF2B5EF4-FFF2-40B4-BE49-F238E27FC236}">
                      <a16:creationId xmlns:a16="http://schemas.microsoft.com/office/drawing/2014/main" id="{C466E2C3-60D9-11A3-0DBD-8F3C1E150C25}"/>
                    </a:ext>
                  </a:extLst>
                </p:cNvPr>
                <p:cNvSpPr/>
                <p:nvPr/>
              </p:nvSpPr>
              <p:spPr>
                <a:xfrm>
                  <a:off x="4796420" y="2732210"/>
                  <a:ext cx="304225" cy="157686"/>
                </a:xfrm>
                <a:prstGeom prst="ellipse">
                  <a:avLst/>
                </a:prstGeom>
                <a:solidFill>
                  <a:srgbClr val="CCECFF"/>
                </a:solidFill>
                <a:ln w="12700">
                  <a:solidFill>
                    <a:srgbClr val="33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44" name="TextBox 143">
                  <a:extLst>
                    <a:ext uri="{FF2B5EF4-FFF2-40B4-BE49-F238E27FC236}">
                      <a16:creationId xmlns:a16="http://schemas.microsoft.com/office/drawing/2014/main" id="{B1A56726-1500-734B-B93E-2AD49C0EC844}"/>
                    </a:ext>
                  </a:extLst>
                </p:cNvPr>
                <p:cNvSpPr txBox="1"/>
                <p:nvPr/>
              </p:nvSpPr>
              <p:spPr>
                <a:xfrm>
                  <a:off x="4731928" y="2657993"/>
                  <a:ext cx="455407" cy="2847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latin typeface="Arial Nova" panose="020B0504020202020204" pitchFamily="34" charset="0"/>
                    </a:rPr>
                    <a:t>Rnd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5E2E4A07-FE49-C307-46CC-88FD8550C255}"/>
              </a:ext>
            </a:extLst>
          </p:cNvPr>
          <p:cNvGrpSpPr/>
          <p:nvPr/>
        </p:nvGrpSpPr>
        <p:grpSpPr>
          <a:xfrm>
            <a:off x="3544888" y="2558959"/>
            <a:ext cx="5270978" cy="2485327"/>
            <a:chOff x="3544888" y="2644684"/>
            <a:chExt cx="5270978" cy="248532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D6A9846-96E9-0515-F222-218D2EEFF3A4}"/>
                </a:ext>
              </a:extLst>
            </p:cNvPr>
            <p:cNvGrpSpPr/>
            <p:nvPr/>
          </p:nvGrpSpPr>
          <p:grpSpPr>
            <a:xfrm>
              <a:off x="3544888" y="2915594"/>
              <a:ext cx="5270978" cy="2214417"/>
              <a:chOff x="3544888" y="2915594"/>
              <a:chExt cx="5270978" cy="2214417"/>
            </a:xfrm>
          </p:grpSpPr>
          <p:sp>
            <p:nvSpPr>
              <p:cNvPr id="172" name="Freeform 23">
                <a:extLst>
                  <a:ext uri="{FF2B5EF4-FFF2-40B4-BE49-F238E27FC236}">
                    <a16:creationId xmlns:a16="http://schemas.microsoft.com/office/drawing/2014/main" id="{6A8C3884-0DB6-72C1-A47F-2DDEACD4E152}"/>
                  </a:ext>
                </a:extLst>
              </p:cNvPr>
              <p:cNvSpPr/>
              <p:nvPr/>
            </p:nvSpPr>
            <p:spPr>
              <a:xfrm rot="20501285">
                <a:off x="6247920" y="3924217"/>
                <a:ext cx="396449" cy="376249"/>
              </a:xfrm>
              <a:custGeom>
                <a:avLst/>
                <a:gdLst>
                  <a:gd name="connsiteX0" fmla="*/ 480405 w 600326"/>
                  <a:gd name="connsiteY0" fmla="*/ 0 h 1019331"/>
                  <a:gd name="connsiteX1" fmla="*/ 45690 w 600326"/>
                  <a:gd name="connsiteY1" fmla="*/ 389744 h 1019331"/>
                  <a:gd name="connsiteX2" fmla="*/ 75670 w 600326"/>
                  <a:gd name="connsiteY2" fmla="*/ 809469 h 1019331"/>
                  <a:gd name="connsiteX3" fmla="*/ 600326 w 600326"/>
                  <a:gd name="connsiteY3" fmla="*/ 1019331 h 1019331"/>
                  <a:gd name="connsiteX4" fmla="*/ 600326 w 600326"/>
                  <a:gd name="connsiteY4" fmla="*/ 1019331 h 10193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00326" h="1019331">
                    <a:moveTo>
                      <a:pt x="480405" y="0"/>
                    </a:moveTo>
                    <a:cubicBezTo>
                      <a:pt x="296775" y="127416"/>
                      <a:pt x="113146" y="254833"/>
                      <a:pt x="45690" y="389744"/>
                    </a:cubicBezTo>
                    <a:cubicBezTo>
                      <a:pt x="-21766" y="524656"/>
                      <a:pt x="-16769" y="704538"/>
                      <a:pt x="75670" y="809469"/>
                    </a:cubicBezTo>
                    <a:cubicBezTo>
                      <a:pt x="168109" y="914400"/>
                      <a:pt x="600326" y="1019331"/>
                      <a:pt x="600326" y="1019331"/>
                    </a:cubicBezTo>
                    <a:lnTo>
                      <a:pt x="600326" y="1019331"/>
                    </a:lnTo>
                  </a:path>
                </a:pathLst>
              </a:custGeom>
              <a:noFill/>
              <a:ln w="38100">
                <a:solidFill>
                  <a:schemeClr val="bg1">
                    <a:lumMod val="85000"/>
                  </a:schemeClr>
                </a:solidFill>
                <a:prstDash val="sysDot"/>
                <a:headEnd type="none" w="med" len="med"/>
                <a:tailEnd type="arrow" w="med" len="med"/>
              </a:ln>
              <a:scene3d>
                <a:camera prst="orthographicFront"/>
                <a:lightRig rig="threePt" dir="t"/>
              </a:scene3d>
              <a:sp3d prstMaterial="matte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 dirty="0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122" name="Group 121">
                <a:extLst>
                  <a:ext uri="{FF2B5EF4-FFF2-40B4-BE49-F238E27FC236}">
                    <a16:creationId xmlns:a16="http://schemas.microsoft.com/office/drawing/2014/main" id="{9B7EA7FC-7CC8-4C3B-A70A-E8B4DD304920}"/>
                  </a:ext>
                </a:extLst>
              </p:cNvPr>
              <p:cNvGrpSpPr/>
              <p:nvPr/>
            </p:nvGrpSpPr>
            <p:grpSpPr>
              <a:xfrm>
                <a:off x="6661643" y="3651852"/>
                <a:ext cx="2154223" cy="934119"/>
                <a:chOff x="2074748" y="-366556"/>
                <a:chExt cx="2154223" cy="1080280"/>
              </a:xfrm>
            </p:grpSpPr>
            <p:cxnSp>
              <p:nvCxnSpPr>
                <p:cNvPr id="349" name="Straight Arrow Connector 348">
                  <a:extLst>
                    <a:ext uri="{FF2B5EF4-FFF2-40B4-BE49-F238E27FC236}">
                      <a16:creationId xmlns:a16="http://schemas.microsoft.com/office/drawing/2014/main" id="{A90598D5-6709-4FE2-BC08-73AAAB73AF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98738" y="-113833"/>
                  <a:ext cx="309232" cy="326468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0" name="Straight Arrow Connector 349">
                  <a:extLst>
                    <a:ext uri="{FF2B5EF4-FFF2-40B4-BE49-F238E27FC236}">
                      <a16:creationId xmlns:a16="http://schemas.microsoft.com/office/drawing/2014/main" id="{9B6421EC-1288-437C-91CB-8C392218B2E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98738" y="-138761"/>
                  <a:ext cx="876263" cy="365298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51" name="Group 350">
                  <a:extLst>
                    <a:ext uri="{FF2B5EF4-FFF2-40B4-BE49-F238E27FC236}">
                      <a16:creationId xmlns:a16="http://schemas.microsoft.com/office/drawing/2014/main" id="{807437CC-09B1-4C88-B42E-23B58D02FFA0}"/>
                    </a:ext>
                  </a:extLst>
                </p:cNvPr>
                <p:cNvGrpSpPr/>
                <p:nvPr/>
              </p:nvGrpSpPr>
              <p:grpSpPr>
                <a:xfrm>
                  <a:off x="3298104" y="227599"/>
                  <a:ext cx="659155" cy="284747"/>
                  <a:chOff x="4128657" y="3486739"/>
                  <a:chExt cx="731370" cy="340418"/>
                </a:xfrm>
              </p:grpSpPr>
              <p:grpSp>
                <p:nvGrpSpPr>
                  <p:cNvPr id="392" name="Group 391">
                    <a:extLst>
                      <a:ext uri="{FF2B5EF4-FFF2-40B4-BE49-F238E27FC236}">
                        <a16:creationId xmlns:a16="http://schemas.microsoft.com/office/drawing/2014/main" id="{4BBFAD29-E094-48AB-96A3-BCE6FC7193FB}"/>
                      </a:ext>
                    </a:extLst>
                  </p:cNvPr>
                  <p:cNvGrpSpPr/>
                  <p:nvPr/>
                </p:nvGrpSpPr>
                <p:grpSpPr>
                  <a:xfrm>
                    <a:off x="4202421" y="3552019"/>
                    <a:ext cx="608667" cy="216827"/>
                    <a:chOff x="4202421" y="3552019"/>
                    <a:chExt cx="608667" cy="216827"/>
                  </a:xfrm>
                </p:grpSpPr>
                <p:sp>
                  <p:nvSpPr>
                    <p:cNvPr id="394" name="Rectangle 393">
                      <a:extLst>
                        <a:ext uri="{FF2B5EF4-FFF2-40B4-BE49-F238E27FC236}">
                          <a16:creationId xmlns:a16="http://schemas.microsoft.com/office/drawing/2014/main" id="{9E90C7CB-E4A2-4435-B7E7-6D98B06F92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06910" y="3565775"/>
                      <a:ext cx="600682" cy="203071"/>
                    </a:xfrm>
                    <a:prstGeom prst="rect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  <p:sp>
                  <p:nvSpPr>
                    <p:cNvPr id="395" name="Rectangle 394">
                      <a:extLst>
                        <a:ext uri="{FF2B5EF4-FFF2-40B4-BE49-F238E27FC236}">
                          <a16:creationId xmlns:a16="http://schemas.microsoft.com/office/drawing/2014/main" id="{C4C76BB3-EDBA-4FF7-9361-A8E65664F69D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398341" y="3356099"/>
                      <a:ext cx="216827" cy="608667"/>
                    </a:xfrm>
                    <a:prstGeom prst="rect">
                      <a:avLst/>
                    </a:prstGeom>
                    <a:noFill/>
                    <a:ln w="285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</p:grpSp>
              <p:sp>
                <p:nvSpPr>
                  <p:cNvPr id="393" name="TextBox 392">
                    <a:extLst>
                      <a:ext uri="{FF2B5EF4-FFF2-40B4-BE49-F238E27FC236}">
                        <a16:creationId xmlns:a16="http://schemas.microsoft.com/office/drawing/2014/main" id="{A83EB20A-914B-4D92-94CA-1E0B320AA44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28657" y="3486739"/>
                    <a:ext cx="731370" cy="340418"/>
                  </a:xfrm>
                  <a:prstGeom prst="rect">
                    <a:avLst/>
                  </a:prstGeom>
                  <a:no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r>
                      <a:rPr lang="en-GB" altLang="en-US" sz="1000" dirty="0" err="1">
                        <a:latin typeface="Arial Nova" panose="020B0504020202020204" pitchFamily="34" charset="0"/>
                      </a:rPr>
                      <a:t>RhoGTP</a:t>
                    </a:r>
                    <a:endParaRPr lang="en-GB" altLang="en-US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cxnSp>
              <p:nvCxnSpPr>
                <p:cNvPr id="352" name="Straight Arrow Connector 351">
                  <a:extLst>
                    <a:ext uri="{FF2B5EF4-FFF2-40B4-BE49-F238E27FC236}">
                      <a16:creationId xmlns:a16="http://schemas.microsoft.com/office/drawing/2014/main" id="{6F3D315B-D5D7-42F7-8E81-0E91235D43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0708" y="498914"/>
                  <a:ext cx="0" cy="187776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53" name="Group 352">
                  <a:extLst>
                    <a:ext uri="{FF2B5EF4-FFF2-40B4-BE49-F238E27FC236}">
                      <a16:creationId xmlns:a16="http://schemas.microsoft.com/office/drawing/2014/main" id="{7790B78D-C808-4E1A-91BB-4E84E69E8C57}"/>
                    </a:ext>
                  </a:extLst>
                </p:cNvPr>
                <p:cNvGrpSpPr/>
                <p:nvPr/>
              </p:nvGrpSpPr>
              <p:grpSpPr>
                <a:xfrm>
                  <a:off x="2698738" y="-270310"/>
                  <a:ext cx="239811" cy="153594"/>
                  <a:chOff x="8498846" y="2384385"/>
                  <a:chExt cx="390511" cy="263789"/>
                </a:xfrm>
              </p:grpSpPr>
              <p:cxnSp>
                <p:nvCxnSpPr>
                  <p:cNvPr id="390" name="Straight Connector 389">
                    <a:extLst>
                      <a:ext uri="{FF2B5EF4-FFF2-40B4-BE49-F238E27FC236}">
                        <a16:creationId xmlns:a16="http://schemas.microsoft.com/office/drawing/2014/main" id="{A3BC9118-F798-4CB8-BD98-26F5781FA216}"/>
                      </a:ext>
                    </a:extLst>
                  </p:cNvPr>
                  <p:cNvCxnSpPr/>
                  <p:nvPr/>
                </p:nvCxnSpPr>
                <p:spPr>
                  <a:xfrm>
                    <a:off x="8498846" y="2514596"/>
                    <a:ext cx="390511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1" name="Straight Connector 390">
                    <a:extLst>
                      <a:ext uri="{FF2B5EF4-FFF2-40B4-BE49-F238E27FC236}">
                        <a16:creationId xmlns:a16="http://schemas.microsoft.com/office/drawing/2014/main" id="{D1DC3B64-F2FC-4F87-A681-08A972862009}"/>
                      </a:ext>
                    </a:extLst>
                  </p:cNvPr>
                  <p:cNvCxnSpPr/>
                  <p:nvPr/>
                </p:nvCxnSpPr>
                <p:spPr>
                  <a:xfrm>
                    <a:off x="8889357" y="2384385"/>
                    <a:ext cx="0" cy="263789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54" name="Group 353">
                  <a:extLst>
                    <a:ext uri="{FF2B5EF4-FFF2-40B4-BE49-F238E27FC236}">
                      <a16:creationId xmlns:a16="http://schemas.microsoft.com/office/drawing/2014/main" id="{D1CF4CA9-E0E5-4EA2-A912-1988E09D3FFB}"/>
                    </a:ext>
                  </a:extLst>
                </p:cNvPr>
                <p:cNvGrpSpPr/>
                <p:nvPr/>
              </p:nvGrpSpPr>
              <p:grpSpPr>
                <a:xfrm>
                  <a:off x="3447910" y="-260643"/>
                  <a:ext cx="167085" cy="166914"/>
                  <a:chOff x="8498846" y="2384385"/>
                  <a:chExt cx="390511" cy="263789"/>
                </a:xfrm>
              </p:grpSpPr>
              <p:cxnSp>
                <p:nvCxnSpPr>
                  <p:cNvPr id="388" name="Straight Connector 387">
                    <a:extLst>
                      <a:ext uri="{FF2B5EF4-FFF2-40B4-BE49-F238E27FC236}">
                        <a16:creationId xmlns:a16="http://schemas.microsoft.com/office/drawing/2014/main" id="{EC6F39B4-1E15-417C-857F-FD672ACB3283}"/>
                      </a:ext>
                    </a:extLst>
                  </p:cNvPr>
                  <p:cNvCxnSpPr/>
                  <p:nvPr/>
                </p:nvCxnSpPr>
                <p:spPr>
                  <a:xfrm>
                    <a:off x="8498846" y="2514596"/>
                    <a:ext cx="390511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9" name="Straight Connector 388">
                    <a:extLst>
                      <a:ext uri="{FF2B5EF4-FFF2-40B4-BE49-F238E27FC236}">
                        <a16:creationId xmlns:a16="http://schemas.microsoft.com/office/drawing/2014/main" id="{640DC08F-4AE3-4810-A430-1437B98896EF}"/>
                      </a:ext>
                    </a:extLst>
                  </p:cNvPr>
                  <p:cNvCxnSpPr/>
                  <p:nvPr/>
                </p:nvCxnSpPr>
                <p:spPr>
                  <a:xfrm>
                    <a:off x="8889357" y="2384385"/>
                    <a:ext cx="0" cy="263789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55" name="Group 354">
                  <a:extLst>
                    <a:ext uri="{FF2B5EF4-FFF2-40B4-BE49-F238E27FC236}">
                      <a16:creationId xmlns:a16="http://schemas.microsoft.com/office/drawing/2014/main" id="{BE301841-0603-4490-A4A5-CD8D093F9641}"/>
                    </a:ext>
                  </a:extLst>
                </p:cNvPr>
                <p:cNvGrpSpPr/>
                <p:nvPr/>
              </p:nvGrpSpPr>
              <p:grpSpPr>
                <a:xfrm>
                  <a:off x="3582640" y="-333082"/>
                  <a:ext cx="646331" cy="284747"/>
                  <a:chOff x="4103307" y="3482689"/>
                  <a:chExt cx="812067" cy="340418"/>
                </a:xfrm>
              </p:grpSpPr>
              <p:grpSp>
                <p:nvGrpSpPr>
                  <p:cNvPr id="384" name="Group 383">
                    <a:extLst>
                      <a:ext uri="{FF2B5EF4-FFF2-40B4-BE49-F238E27FC236}">
                        <a16:creationId xmlns:a16="http://schemas.microsoft.com/office/drawing/2014/main" id="{EFA4FBA4-0399-4A6D-8013-72AFC53A1EAA}"/>
                      </a:ext>
                    </a:extLst>
                  </p:cNvPr>
                  <p:cNvGrpSpPr/>
                  <p:nvPr/>
                </p:nvGrpSpPr>
                <p:grpSpPr>
                  <a:xfrm>
                    <a:off x="4202421" y="3552019"/>
                    <a:ext cx="608667" cy="216827"/>
                    <a:chOff x="4202421" y="3552019"/>
                    <a:chExt cx="608667" cy="216827"/>
                  </a:xfrm>
                </p:grpSpPr>
                <p:sp>
                  <p:nvSpPr>
                    <p:cNvPr id="386" name="Rectangle 385">
                      <a:extLst>
                        <a:ext uri="{FF2B5EF4-FFF2-40B4-BE49-F238E27FC236}">
                          <a16:creationId xmlns:a16="http://schemas.microsoft.com/office/drawing/2014/main" id="{70B1BAFC-702B-4660-8956-1528DE6DB4D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06910" y="3565775"/>
                      <a:ext cx="600682" cy="203071"/>
                    </a:xfrm>
                    <a:prstGeom prst="rect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  <p:sp>
                  <p:nvSpPr>
                    <p:cNvPr id="387" name="Rectangle 386">
                      <a:extLst>
                        <a:ext uri="{FF2B5EF4-FFF2-40B4-BE49-F238E27FC236}">
                          <a16:creationId xmlns:a16="http://schemas.microsoft.com/office/drawing/2014/main" id="{687B5D37-5666-4F9A-8C19-67A268BBB30A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398341" y="3356099"/>
                      <a:ext cx="216827" cy="608667"/>
                    </a:xfrm>
                    <a:prstGeom prst="rect">
                      <a:avLst/>
                    </a:prstGeom>
                    <a:noFill/>
                    <a:ln w="285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</p:grpSp>
              <p:sp>
                <p:nvSpPr>
                  <p:cNvPr id="385" name="TextBox 384">
                    <a:extLst>
                      <a:ext uri="{FF2B5EF4-FFF2-40B4-BE49-F238E27FC236}">
                        <a16:creationId xmlns:a16="http://schemas.microsoft.com/office/drawing/2014/main" id="{FED68896-8444-4E95-AAA8-BA7B098EFD3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03307" y="3482689"/>
                    <a:ext cx="812067" cy="340418"/>
                  </a:xfrm>
                  <a:prstGeom prst="rect">
                    <a:avLst/>
                  </a:prstGeom>
                  <a:no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r>
                      <a:rPr lang="en-GB" altLang="en-US" sz="1000" dirty="0" err="1">
                        <a:latin typeface="Arial Nova" panose="020B0504020202020204" pitchFamily="34" charset="0"/>
                      </a:rPr>
                      <a:t>RasGTP</a:t>
                    </a:r>
                    <a:endParaRPr lang="en-GB" altLang="en-US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sp>
              <p:nvSpPr>
                <p:cNvPr id="356" name="Freeform: Shape 355">
                  <a:extLst>
                    <a:ext uri="{FF2B5EF4-FFF2-40B4-BE49-F238E27FC236}">
                      <a16:creationId xmlns:a16="http://schemas.microsoft.com/office/drawing/2014/main" id="{C4E351DA-6E74-44F3-AF2A-5186180DA5EF}"/>
                    </a:ext>
                  </a:extLst>
                </p:cNvPr>
                <p:cNvSpPr/>
                <p:nvPr/>
              </p:nvSpPr>
              <p:spPr>
                <a:xfrm rot="21066366">
                  <a:off x="3628408" y="-20104"/>
                  <a:ext cx="344141" cy="733828"/>
                </a:xfrm>
                <a:custGeom>
                  <a:avLst/>
                  <a:gdLst>
                    <a:gd name="connsiteX0" fmla="*/ 416689 w 499712"/>
                    <a:gd name="connsiteY0" fmla="*/ 0 h 943337"/>
                    <a:gd name="connsiteX1" fmla="*/ 468775 w 499712"/>
                    <a:gd name="connsiteY1" fmla="*/ 578734 h 943337"/>
                    <a:gd name="connsiteX2" fmla="*/ 0 w 499712"/>
                    <a:gd name="connsiteY2" fmla="*/ 943337 h 943337"/>
                    <a:gd name="connsiteX3" fmla="*/ 0 w 499712"/>
                    <a:gd name="connsiteY3" fmla="*/ 943337 h 94333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99712" h="943337">
                      <a:moveTo>
                        <a:pt x="416689" y="0"/>
                      </a:moveTo>
                      <a:cubicBezTo>
                        <a:pt x="477456" y="210755"/>
                        <a:pt x="538223" y="421511"/>
                        <a:pt x="468775" y="578734"/>
                      </a:cubicBezTo>
                      <a:cubicBezTo>
                        <a:pt x="399327" y="735957"/>
                        <a:pt x="0" y="943337"/>
                        <a:pt x="0" y="943337"/>
                      </a:cubicBezTo>
                      <a:lnTo>
                        <a:pt x="0" y="943337"/>
                      </a:ln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  <a:headEnd type="none" w="med" len="med"/>
                  <a:tailEnd type="arrow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  <p:grpSp>
              <p:nvGrpSpPr>
                <p:cNvPr id="357" name="Group 356">
                  <a:extLst>
                    <a:ext uri="{FF2B5EF4-FFF2-40B4-BE49-F238E27FC236}">
                      <a16:creationId xmlns:a16="http://schemas.microsoft.com/office/drawing/2014/main" id="{66B32E61-C09F-4E60-B86C-59C30105D1AD}"/>
                    </a:ext>
                  </a:extLst>
                </p:cNvPr>
                <p:cNvGrpSpPr/>
                <p:nvPr/>
              </p:nvGrpSpPr>
              <p:grpSpPr>
                <a:xfrm>
                  <a:off x="2915146" y="-366556"/>
                  <a:ext cx="659196" cy="388287"/>
                  <a:chOff x="8507624" y="2501392"/>
                  <a:chExt cx="828233" cy="464201"/>
                </a:xfrm>
              </p:grpSpPr>
              <p:sp>
                <p:nvSpPr>
                  <p:cNvPr id="382" name="TextBox 381">
                    <a:extLst>
                      <a:ext uri="{FF2B5EF4-FFF2-40B4-BE49-F238E27FC236}">
                        <a16:creationId xmlns:a16="http://schemas.microsoft.com/office/drawing/2014/main" id="{BEA44983-2F09-4183-B7E1-1E718A5CBFAC}"/>
                      </a:ext>
                    </a:extLst>
                  </p:cNvPr>
                  <p:cNvSpPr txBox="1"/>
                  <p:nvPr/>
                </p:nvSpPr>
                <p:spPr>
                  <a:xfrm>
                    <a:off x="8507624" y="2501392"/>
                    <a:ext cx="590521" cy="34041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>
                        <a:latin typeface="Arial Nova" panose="020B0504020202020204" pitchFamily="34" charset="0"/>
                      </a:rPr>
                      <a:t>p120</a:t>
                    </a:r>
                  </a:p>
                </p:txBody>
              </p:sp>
              <p:sp>
                <p:nvSpPr>
                  <p:cNvPr id="383" name="Rectangle 382">
                    <a:extLst>
                      <a:ext uri="{FF2B5EF4-FFF2-40B4-BE49-F238E27FC236}">
                        <a16:creationId xmlns:a16="http://schemas.microsoft.com/office/drawing/2014/main" id="{76BD9F38-6DC8-47EF-B7B6-67167F7C00A0}"/>
                      </a:ext>
                    </a:extLst>
                  </p:cNvPr>
                  <p:cNvSpPr/>
                  <p:nvPr/>
                </p:nvSpPr>
                <p:spPr>
                  <a:xfrm>
                    <a:off x="8511704" y="2625175"/>
                    <a:ext cx="824153" cy="34041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000" dirty="0" err="1">
                        <a:latin typeface="Arial Nova" panose="020B0504020202020204" pitchFamily="34" charset="0"/>
                      </a:rPr>
                      <a:t>RasGAP</a:t>
                    </a:r>
                    <a:endParaRPr lang="en-GB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cxnSp>
              <p:nvCxnSpPr>
                <p:cNvPr id="358" name="Straight Arrow Connector 357">
                  <a:extLst>
                    <a:ext uri="{FF2B5EF4-FFF2-40B4-BE49-F238E27FC236}">
                      <a16:creationId xmlns:a16="http://schemas.microsoft.com/office/drawing/2014/main" id="{60F709AD-772B-4DEB-8CA0-2225CCCB5D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74727" y="495340"/>
                  <a:ext cx="0" cy="187776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61" name="Group 360">
                  <a:extLst>
                    <a:ext uri="{FF2B5EF4-FFF2-40B4-BE49-F238E27FC236}">
                      <a16:creationId xmlns:a16="http://schemas.microsoft.com/office/drawing/2014/main" id="{71616DBF-3D55-43CC-B355-93536322F0D3}"/>
                    </a:ext>
                  </a:extLst>
                </p:cNvPr>
                <p:cNvGrpSpPr/>
                <p:nvPr/>
              </p:nvGrpSpPr>
              <p:grpSpPr>
                <a:xfrm>
                  <a:off x="2074748" y="-285392"/>
                  <a:ext cx="659155" cy="284747"/>
                  <a:chOff x="4131815" y="3494188"/>
                  <a:chExt cx="760486" cy="340418"/>
                </a:xfrm>
              </p:grpSpPr>
              <p:grpSp>
                <p:nvGrpSpPr>
                  <p:cNvPr id="367" name="Group 366">
                    <a:extLst>
                      <a:ext uri="{FF2B5EF4-FFF2-40B4-BE49-F238E27FC236}">
                        <a16:creationId xmlns:a16="http://schemas.microsoft.com/office/drawing/2014/main" id="{F9277569-759D-4D71-931F-1BF351A818A5}"/>
                      </a:ext>
                    </a:extLst>
                  </p:cNvPr>
                  <p:cNvGrpSpPr/>
                  <p:nvPr/>
                </p:nvGrpSpPr>
                <p:grpSpPr>
                  <a:xfrm>
                    <a:off x="4202421" y="3552019"/>
                    <a:ext cx="608667" cy="216827"/>
                    <a:chOff x="4202421" y="3552019"/>
                    <a:chExt cx="608667" cy="216827"/>
                  </a:xfrm>
                </p:grpSpPr>
                <p:sp>
                  <p:nvSpPr>
                    <p:cNvPr id="369" name="Rectangle 368">
                      <a:extLst>
                        <a:ext uri="{FF2B5EF4-FFF2-40B4-BE49-F238E27FC236}">
                          <a16:creationId xmlns:a16="http://schemas.microsoft.com/office/drawing/2014/main" id="{1A437485-4E8F-4765-8CB8-341BB8FA340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06910" y="3565775"/>
                      <a:ext cx="600682" cy="203071"/>
                    </a:xfrm>
                    <a:prstGeom prst="rect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  <p:sp>
                  <p:nvSpPr>
                    <p:cNvPr id="370" name="Rectangle 369">
                      <a:extLst>
                        <a:ext uri="{FF2B5EF4-FFF2-40B4-BE49-F238E27FC236}">
                          <a16:creationId xmlns:a16="http://schemas.microsoft.com/office/drawing/2014/main" id="{FD068556-4889-491A-BBB2-7045F0D03ECF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398341" y="3356099"/>
                      <a:ext cx="216827" cy="608667"/>
                    </a:xfrm>
                    <a:prstGeom prst="rect">
                      <a:avLst/>
                    </a:prstGeom>
                    <a:noFill/>
                    <a:ln w="285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</p:grpSp>
              <p:sp>
                <p:nvSpPr>
                  <p:cNvPr id="368" name="TextBox 367">
                    <a:extLst>
                      <a:ext uri="{FF2B5EF4-FFF2-40B4-BE49-F238E27FC236}">
                        <a16:creationId xmlns:a16="http://schemas.microsoft.com/office/drawing/2014/main" id="{11C539BE-1199-4AF1-B17B-F3AB6AFC769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31815" y="3494188"/>
                    <a:ext cx="760486" cy="340418"/>
                  </a:xfrm>
                  <a:prstGeom prst="rect">
                    <a:avLst/>
                  </a:prstGeom>
                  <a:no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r>
                      <a:rPr lang="en-GB" altLang="en-US" sz="1000" dirty="0" err="1">
                        <a:latin typeface="Arial Nova" panose="020B0504020202020204" pitchFamily="34" charset="0"/>
                      </a:rPr>
                      <a:t>RapGTP</a:t>
                    </a:r>
                    <a:endParaRPr lang="en-GB" altLang="en-US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grpSp>
              <p:nvGrpSpPr>
                <p:cNvPr id="362" name="Group 361">
                  <a:extLst>
                    <a:ext uri="{FF2B5EF4-FFF2-40B4-BE49-F238E27FC236}">
                      <a16:creationId xmlns:a16="http://schemas.microsoft.com/office/drawing/2014/main" id="{05638758-BF87-44CB-A980-A3E405D3F165}"/>
                    </a:ext>
                  </a:extLst>
                </p:cNvPr>
                <p:cNvGrpSpPr/>
                <p:nvPr/>
              </p:nvGrpSpPr>
              <p:grpSpPr>
                <a:xfrm>
                  <a:off x="2685691" y="211538"/>
                  <a:ext cx="652743" cy="284747"/>
                  <a:chOff x="4101408" y="3479175"/>
                  <a:chExt cx="820125" cy="340418"/>
                </a:xfrm>
              </p:grpSpPr>
              <p:grpSp>
                <p:nvGrpSpPr>
                  <p:cNvPr id="363" name="Group 362">
                    <a:extLst>
                      <a:ext uri="{FF2B5EF4-FFF2-40B4-BE49-F238E27FC236}">
                        <a16:creationId xmlns:a16="http://schemas.microsoft.com/office/drawing/2014/main" id="{90CFC43F-0A04-4C1D-8661-DE402841DE08}"/>
                      </a:ext>
                    </a:extLst>
                  </p:cNvPr>
                  <p:cNvGrpSpPr/>
                  <p:nvPr/>
                </p:nvGrpSpPr>
                <p:grpSpPr>
                  <a:xfrm>
                    <a:off x="4202421" y="3552019"/>
                    <a:ext cx="608667" cy="216827"/>
                    <a:chOff x="4202421" y="3552019"/>
                    <a:chExt cx="608667" cy="216827"/>
                  </a:xfrm>
                </p:grpSpPr>
                <p:sp>
                  <p:nvSpPr>
                    <p:cNvPr id="365" name="Rectangle 364">
                      <a:extLst>
                        <a:ext uri="{FF2B5EF4-FFF2-40B4-BE49-F238E27FC236}">
                          <a16:creationId xmlns:a16="http://schemas.microsoft.com/office/drawing/2014/main" id="{CF80F4DE-D731-4454-9CD2-1F1A62E6187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06910" y="3565775"/>
                      <a:ext cx="600682" cy="203071"/>
                    </a:xfrm>
                    <a:prstGeom prst="rect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  <p:sp>
                  <p:nvSpPr>
                    <p:cNvPr id="366" name="Rectangle 365">
                      <a:extLst>
                        <a:ext uri="{FF2B5EF4-FFF2-40B4-BE49-F238E27FC236}">
                          <a16:creationId xmlns:a16="http://schemas.microsoft.com/office/drawing/2014/main" id="{783F9473-8E44-4E23-BC22-D26177820BA2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398341" y="3356099"/>
                      <a:ext cx="216827" cy="608667"/>
                    </a:xfrm>
                    <a:prstGeom prst="rect">
                      <a:avLst/>
                    </a:prstGeom>
                    <a:noFill/>
                    <a:ln w="285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sz="1000">
                        <a:latin typeface="Arial Nova" panose="020B0504020202020204" pitchFamily="34" charset="0"/>
                      </a:endParaRPr>
                    </a:p>
                  </p:txBody>
                </p:sp>
              </p:grpSp>
              <p:sp>
                <p:nvSpPr>
                  <p:cNvPr id="364" name="TextBox 363">
                    <a:extLst>
                      <a:ext uri="{FF2B5EF4-FFF2-40B4-BE49-F238E27FC236}">
                        <a16:creationId xmlns:a16="http://schemas.microsoft.com/office/drawing/2014/main" id="{364612F5-A8BA-4F31-A6EB-53F966C5F2E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01408" y="3479175"/>
                    <a:ext cx="820125" cy="340418"/>
                  </a:xfrm>
                  <a:prstGeom prst="rect">
                    <a:avLst/>
                  </a:prstGeom>
                  <a:no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r>
                      <a:rPr lang="en-GB" altLang="en-US" sz="1000" dirty="0" err="1">
                        <a:latin typeface="Arial Nova" panose="020B0504020202020204" pitchFamily="34" charset="0"/>
                      </a:rPr>
                      <a:t>RacGTP</a:t>
                    </a:r>
                    <a:endParaRPr lang="en-GB" altLang="en-US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</p:grpSp>
          <p:sp>
            <p:nvSpPr>
              <p:cNvPr id="164" name="Freeform: Shape 163">
                <a:extLst>
                  <a:ext uri="{FF2B5EF4-FFF2-40B4-BE49-F238E27FC236}">
                    <a16:creationId xmlns:a16="http://schemas.microsoft.com/office/drawing/2014/main" id="{063BBA9F-C9A8-9FC4-E577-FF6D5C09829E}"/>
                  </a:ext>
                </a:extLst>
              </p:cNvPr>
              <p:cNvSpPr/>
              <p:nvPr/>
            </p:nvSpPr>
            <p:spPr>
              <a:xfrm>
                <a:off x="4652684" y="3780403"/>
                <a:ext cx="1038644" cy="879948"/>
              </a:xfrm>
              <a:custGeom>
                <a:avLst/>
                <a:gdLst>
                  <a:gd name="connsiteX0" fmla="*/ 703443 w 1147258"/>
                  <a:gd name="connsiteY0" fmla="*/ 38100 h 1017633"/>
                  <a:gd name="connsiteX1" fmla="*/ 1113018 w 1147258"/>
                  <a:gd name="connsiteY1" fmla="*/ 266700 h 1017633"/>
                  <a:gd name="connsiteX2" fmla="*/ 1103493 w 1147258"/>
                  <a:gd name="connsiteY2" fmla="*/ 771525 h 1017633"/>
                  <a:gd name="connsiteX3" fmla="*/ 932043 w 1147258"/>
                  <a:gd name="connsiteY3" fmla="*/ 895350 h 1017633"/>
                  <a:gd name="connsiteX4" fmla="*/ 589143 w 1147258"/>
                  <a:gd name="connsiteY4" fmla="*/ 1000125 h 1017633"/>
                  <a:gd name="connsiteX5" fmla="*/ 265293 w 1147258"/>
                  <a:gd name="connsiteY5" fmla="*/ 1000125 h 1017633"/>
                  <a:gd name="connsiteX6" fmla="*/ 17643 w 1147258"/>
                  <a:gd name="connsiteY6" fmla="*/ 828675 h 1017633"/>
                  <a:gd name="connsiteX7" fmla="*/ 27168 w 1147258"/>
                  <a:gd name="connsiteY7" fmla="*/ 723900 h 1017633"/>
                  <a:gd name="connsiteX8" fmla="*/ 84318 w 1147258"/>
                  <a:gd name="connsiteY8" fmla="*/ 638175 h 1017633"/>
                  <a:gd name="connsiteX9" fmla="*/ 227193 w 1147258"/>
                  <a:gd name="connsiteY9" fmla="*/ 590550 h 1017633"/>
                  <a:gd name="connsiteX10" fmla="*/ 303393 w 1147258"/>
                  <a:gd name="connsiteY10" fmla="*/ 581025 h 1017633"/>
                  <a:gd name="connsiteX11" fmla="*/ 455793 w 1147258"/>
                  <a:gd name="connsiteY11" fmla="*/ 676275 h 1017633"/>
                  <a:gd name="connsiteX12" fmla="*/ 608193 w 1147258"/>
                  <a:gd name="connsiteY12" fmla="*/ 647700 h 1017633"/>
                  <a:gd name="connsiteX13" fmla="*/ 760593 w 1147258"/>
                  <a:gd name="connsiteY13" fmla="*/ 542925 h 1017633"/>
                  <a:gd name="connsiteX14" fmla="*/ 827268 w 1147258"/>
                  <a:gd name="connsiteY14" fmla="*/ 419100 h 1017633"/>
                  <a:gd name="connsiteX15" fmla="*/ 712968 w 1147258"/>
                  <a:gd name="connsiteY15" fmla="*/ 266700 h 1017633"/>
                  <a:gd name="connsiteX16" fmla="*/ 589143 w 1147258"/>
                  <a:gd name="connsiteY16" fmla="*/ 180975 h 1017633"/>
                  <a:gd name="connsiteX17" fmla="*/ 541518 w 1147258"/>
                  <a:gd name="connsiteY17" fmla="*/ 57150 h 1017633"/>
                  <a:gd name="connsiteX18" fmla="*/ 655818 w 1147258"/>
                  <a:gd name="connsiteY18" fmla="*/ 0 h 10176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1147258" h="1017633">
                    <a:moveTo>
                      <a:pt x="703443" y="38100"/>
                    </a:moveTo>
                    <a:cubicBezTo>
                      <a:pt x="874893" y="91281"/>
                      <a:pt x="1046343" y="144463"/>
                      <a:pt x="1113018" y="266700"/>
                    </a:cubicBezTo>
                    <a:cubicBezTo>
                      <a:pt x="1179693" y="388938"/>
                      <a:pt x="1133655" y="666750"/>
                      <a:pt x="1103493" y="771525"/>
                    </a:cubicBezTo>
                    <a:cubicBezTo>
                      <a:pt x="1073331" y="876300"/>
                      <a:pt x="1017768" y="857250"/>
                      <a:pt x="932043" y="895350"/>
                    </a:cubicBezTo>
                    <a:cubicBezTo>
                      <a:pt x="846318" y="933450"/>
                      <a:pt x="700268" y="982663"/>
                      <a:pt x="589143" y="1000125"/>
                    </a:cubicBezTo>
                    <a:cubicBezTo>
                      <a:pt x="478018" y="1017588"/>
                      <a:pt x="360543" y="1028700"/>
                      <a:pt x="265293" y="1000125"/>
                    </a:cubicBezTo>
                    <a:cubicBezTo>
                      <a:pt x="170043" y="971550"/>
                      <a:pt x="57330" y="874712"/>
                      <a:pt x="17643" y="828675"/>
                    </a:cubicBezTo>
                    <a:cubicBezTo>
                      <a:pt x="-22044" y="782638"/>
                      <a:pt x="16056" y="755650"/>
                      <a:pt x="27168" y="723900"/>
                    </a:cubicBezTo>
                    <a:cubicBezTo>
                      <a:pt x="38280" y="692150"/>
                      <a:pt x="50981" y="660400"/>
                      <a:pt x="84318" y="638175"/>
                    </a:cubicBezTo>
                    <a:cubicBezTo>
                      <a:pt x="117655" y="615950"/>
                      <a:pt x="190681" y="600075"/>
                      <a:pt x="227193" y="590550"/>
                    </a:cubicBezTo>
                    <a:cubicBezTo>
                      <a:pt x="263705" y="581025"/>
                      <a:pt x="265293" y="566738"/>
                      <a:pt x="303393" y="581025"/>
                    </a:cubicBezTo>
                    <a:cubicBezTo>
                      <a:pt x="341493" y="595312"/>
                      <a:pt x="404993" y="665163"/>
                      <a:pt x="455793" y="676275"/>
                    </a:cubicBezTo>
                    <a:cubicBezTo>
                      <a:pt x="506593" y="687388"/>
                      <a:pt x="557393" y="669925"/>
                      <a:pt x="608193" y="647700"/>
                    </a:cubicBezTo>
                    <a:cubicBezTo>
                      <a:pt x="658993" y="625475"/>
                      <a:pt x="724081" y="581025"/>
                      <a:pt x="760593" y="542925"/>
                    </a:cubicBezTo>
                    <a:cubicBezTo>
                      <a:pt x="797105" y="504825"/>
                      <a:pt x="835205" y="465137"/>
                      <a:pt x="827268" y="419100"/>
                    </a:cubicBezTo>
                    <a:cubicBezTo>
                      <a:pt x="819331" y="373063"/>
                      <a:pt x="752655" y="306387"/>
                      <a:pt x="712968" y="266700"/>
                    </a:cubicBezTo>
                    <a:cubicBezTo>
                      <a:pt x="673281" y="227013"/>
                      <a:pt x="617718" y="215900"/>
                      <a:pt x="589143" y="180975"/>
                    </a:cubicBezTo>
                    <a:cubicBezTo>
                      <a:pt x="560568" y="146050"/>
                      <a:pt x="530406" y="87312"/>
                      <a:pt x="541518" y="57150"/>
                    </a:cubicBezTo>
                    <a:cubicBezTo>
                      <a:pt x="552630" y="26988"/>
                      <a:pt x="604224" y="13494"/>
                      <a:pt x="655818" y="0"/>
                    </a:cubicBezTo>
                  </a:path>
                </a:pathLst>
              </a:custGeom>
              <a:solidFill>
                <a:srgbClr val="CCE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65" name="Oval 164">
                <a:extLst>
                  <a:ext uri="{FF2B5EF4-FFF2-40B4-BE49-F238E27FC236}">
                    <a16:creationId xmlns:a16="http://schemas.microsoft.com/office/drawing/2014/main" id="{EFFB6790-959E-9C0D-7081-0E49AAAE9F2B}"/>
                  </a:ext>
                </a:extLst>
              </p:cNvPr>
              <p:cNvSpPr/>
              <p:nvPr/>
            </p:nvSpPr>
            <p:spPr>
              <a:xfrm rot="2059538">
                <a:off x="5313572" y="4160364"/>
                <a:ext cx="377339" cy="442715"/>
              </a:xfrm>
              <a:prstGeom prst="ellipse">
                <a:avLst/>
              </a:prstGeom>
              <a:solidFill>
                <a:srgbClr val="E1F4FF"/>
              </a:solidFill>
              <a:ln>
                <a:solidFill>
                  <a:srgbClr val="CCEC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66" name="Freeform: Shape 165">
                <a:extLst>
                  <a:ext uri="{FF2B5EF4-FFF2-40B4-BE49-F238E27FC236}">
                    <a16:creationId xmlns:a16="http://schemas.microsoft.com/office/drawing/2014/main" id="{E1E77B8F-0D23-0D60-14FB-916400959855}"/>
                  </a:ext>
                </a:extLst>
              </p:cNvPr>
              <p:cNvSpPr/>
              <p:nvPr/>
            </p:nvSpPr>
            <p:spPr>
              <a:xfrm flipH="1">
                <a:off x="5807521" y="3819807"/>
                <a:ext cx="1038644" cy="879948"/>
              </a:xfrm>
              <a:custGeom>
                <a:avLst/>
                <a:gdLst>
                  <a:gd name="connsiteX0" fmla="*/ 703443 w 1147258"/>
                  <a:gd name="connsiteY0" fmla="*/ 38100 h 1017633"/>
                  <a:gd name="connsiteX1" fmla="*/ 1113018 w 1147258"/>
                  <a:gd name="connsiteY1" fmla="*/ 266700 h 1017633"/>
                  <a:gd name="connsiteX2" fmla="*/ 1103493 w 1147258"/>
                  <a:gd name="connsiteY2" fmla="*/ 771525 h 1017633"/>
                  <a:gd name="connsiteX3" fmla="*/ 932043 w 1147258"/>
                  <a:gd name="connsiteY3" fmla="*/ 895350 h 1017633"/>
                  <a:gd name="connsiteX4" fmla="*/ 589143 w 1147258"/>
                  <a:gd name="connsiteY4" fmla="*/ 1000125 h 1017633"/>
                  <a:gd name="connsiteX5" fmla="*/ 265293 w 1147258"/>
                  <a:gd name="connsiteY5" fmla="*/ 1000125 h 1017633"/>
                  <a:gd name="connsiteX6" fmla="*/ 17643 w 1147258"/>
                  <a:gd name="connsiteY6" fmla="*/ 828675 h 1017633"/>
                  <a:gd name="connsiteX7" fmla="*/ 27168 w 1147258"/>
                  <a:gd name="connsiteY7" fmla="*/ 723900 h 1017633"/>
                  <a:gd name="connsiteX8" fmla="*/ 84318 w 1147258"/>
                  <a:gd name="connsiteY8" fmla="*/ 638175 h 1017633"/>
                  <a:gd name="connsiteX9" fmla="*/ 227193 w 1147258"/>
                  <a:gd name="connsiteY9" fmla="*/ 590550 h 1017633"/>
                  <a:gd name="connsiteX10" fmla="*/ 303393 w 1147258"/>
                  <a:gd name="connsiteY10" fmla="*/ 581025 h 1017633"/>
                  <a:gd name="connsiteX11" fmla="*/ 455793 w 1147258"/>
                  <a:gd name="connsiteY11" fmla="*/ 676275 h 1017633"/>
                  <a:gd name="connsiteX12" fmla="*/ 608193 w 1147258"/>
                  <a:gd name="connsiteY12" fmla="*/ 647700 h 1017633"/>
                  <a:gd name="connsiteX13" fmla="*/ 760593 w 1147258"/>
                  <a:gd name="connsiteY13" fmla="*/ 542925 h 1017633"/>
                  <a:gd name="connsiteX14" fmla="*/ 827268 w 1147258"/>
                  <a:gd name="connsiteY14" fmla="*/ 419100 h 1017633"/>
                  <a:gd name="connsiteX15" fmla="*/ 712968 w 1147258"/>
                  <a:gd name="connsiteY15" fmla="*/ 266700 h 1017633"/>
                  <a:gd name="connsiteX16" fmla="*/ 589143 w 1147258"/>
                  <a:gd name="connsiteY16" fmla="*/ 180975 h 1017633"/>
                  <a:gd name="connsiteX17" fmla="*/ 541518 w 1147258"/>
                  <a:gd name="connsiteY17" fmla="*/ 57150 h 1017633"/>
                  <a:gd name="connsiteX18" fmla="*/ 655818 w 1147258"/>
                  <a:gd name="connsiteY18" fmla="*/ 0 h 10176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1147258" h="1017633">
                    <a:moveTo>
                      <a:pt x="703443" y="38100"/>
                    </a:moveTo>
                    <a:cubicBezTo>
                      <a:pt x="874893" y="91281"/>
                      <a:pt x="1046343" y="144463"/>
                      <a:pt x="1113018" y="266700"/>
                    </a:cubicBezTo>
                    <a:cubicBezTo>
                      <a:pt x="1179693" y="388938"/>
                      <a:pt x="1133655" y="666750"/>
                      <a:pt x="1103493" y="771525"/>
                    </a:cubicBezTo>
                    <a:cubicBezTo>
                      <a:pt x="1073331" y="876300"/>
                      <a:pt x="1017768" y="857250"/>
                      <a:pt x="932043" y="895350"/>
                    </a:cubicBezTo>
                    <a:cubicBezTo>
                      <a:pt x="846318" y="933450"/>
                      <a:pt x="700268" y="982663"/>
                      <a:pt x="589143" y="1000125"/>
                    </a:cubicBezTo>
                    <a:cubicBezTo>
                      <a:pt x="478018" y="1017588"/>
                      <a:pt x="360543" y="1028700"/>
                      <a:pt x="265293" y="1000125"/>
                    </a:cubicBezTo>
                    <a:cubicBezTo>
                      <a:pt x="170043" y="971550"/>
                      <a:pt x="57330" y="874712"/>
                      <a:pt x="17643" y="828675"/>
                    </a:cubicBezTo>
                    <a:cubicBezTo>
                      <a:pt x="-22044" y="782638"/>
                      <a:pt x="16056" y="755650"/>
                      <a:pt x="27168" y="723900"/>
                    </a:cubicBezTo>
                    <a:cubicBezTo>
                      <a:pt x="38280" y="692150"/>
                      <a:pt x="50981" y="660400"/>
                      <a:pt x="84318" y="638175"/>
                    </a:cubicBezTo>
                    <a:cubicBezTo>
                      <a:pt x="117655" y="615950"/>
                      <a:pt x="190681" y="600075"/>
                      <a:pt x="227193" y="590550"/>
                    </a:cubicBezTo>
                    <a:cubicBezTo>
                      <a:pt x="263705" y="581025"/>
                      <a:pt x="265293" y="566738"/>
                      <a:pt x="303393" y="581025"/>
                    </a:cubicBezTo>
                    <a:cubicBezTo>
                      <a:pt x="341493" y="595312"/>
                      <a:pt x="404993" y="665163"/>
                      <a:pt x="455793" y="676275"/>
                    </a:cubicBezTo>
                    <a:cubicBezTo>
                      <a:pt x="506593" y="687388"/>
                      <a:pt x="557393" y="669925"/>
                      <a:pt x="608193" y="647700"/>
                    </a:cubicBezTo>
                    <a:cubicBezTo>
                      <a:pt x="658993" y="625475"/>
                      <a:pt x="724081" y="581025"/>
                      <a:pt x="760593" y="542925"/>
                    </a:cubicBezTo>
                    <a:cubicBezTo>
                      <a:pt x="797105" y="504825"/>
                      <a:pt x="835205" y="465137"/>
                      <a:pt x="827268" y="419100"/>
                    </a:cubicBezTo>
                    <a:cubicBezTo>
                      <a:pt x="819331" y="373063"/>
                      <a:pt x="752655" y="306387"/>
                      <a:pt x="712968" y="266700"/>
                    </a:cubicBezTo>
                    <a:cubicBezTo>
                      <a:pt x="673281" y="227013"/>
                      <a:pt x="617718" y="215900"/>
                      <a:pt x="589143" y="180975"/>
                    </a:cubicBezTo>
                    <a:cubicBezTo>
                      <a:pt x="560568" y="146050"/>
                      <a:pt x="530406" y="87312"/>
                      <a:pt x="541518" y="57150"/>
                    </a:cubicBezTo>
                    <a:cubicBezTo>
                      <a:pt x="552630" y="26988"/>
                      <a:pt x="604224" y="13494"/>
                      <a:pt x="655818" y="0"/>
                    </a:cubicBezTo>
                  </a:path>
                </a:pathLst>
              </a:custGeom>
              <a:solidFill>
                <a:srgbClr val="CCE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67" name="Oval 166">
                <a:extLst>
                  <a:ext uri="{FF2B5EF4-FFF2-40B4-BE49-F238E27FC236}">
                    <a16:creationId xmlns:a16="http://schemas.microsoft.com/office/drawing/2014/main" id="{B8C77B80-42F9-E99C-6CA0-86746A8A192A}"/>
                  </a:ext>
                </a:extLst>
              </p:cNvPr>
              <p:cNvSpPr/>
              <p:nvPr/>
            </p:nvSpPr>
            <p:spPr>
              <a:xfrm rot="19540462" flipH="1">
                <a:off x="5801115" y="4185488"/>
                <a:ext cx="377339" cy="442715"/>
              </a:xfrm>
              <a:prstGeom prst="ellipse">
                <a:avLst/>
              </a:prstGeom>
              <a:solidFill>
                <a:srgbClr val="E1F4FF"/>
              </a:solidFill>
              <a:ln>
                <a:solidFill>
                  <a:srgbClr val="CCEC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68" name="Rectangle 167">
                <a:extLst>
                  <a:ext uri="{FF2B5EF4-FFF2-40B4-BE49-F238E27FC236}">
                    <a16:creationId xmlns:a16="http://schemas.microsoft.com/office/drawing/2014/main" id="{2154D304-0B17-0B36-ED46-630C88FF52D8}"/>
                  </a:ext>
                </a:extLst>
              </p:cNvPr>
              <p:cNvSpPr/>
              <p:nvPr/>
            </p:nvSpPr>
            <p:spPr>
              <a:xfrm>
                <a:off x="5638232" y="2915594"/>
                <a:ext cx="75074" cy="1222575"/>
              </a:xfrm>
              <a:prstGeom prst="rect">
                <a:avLst/>
              </a:prstGeom>
              <a:solidFill>
                <a:srgbClr val="CCE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69" name="Rectangle 168">
                <a:extLst>
                  <a:ext uri="{FF2B5EF4-FFF2-40B4-BE49-F238E27FC236}">
                    <a16:creationId xmlns:a16="http://schemas.microsoft.com/office/drawing/2014/main" id="{0926394E-8C07-8B96-CD02-4B016C4D1155}"/>
                  </a:ext>
                </a:extLst>
              </p:cNvPr>
              <p:cNvSpPr/>
              <p:nvPr/>
            </p:nvSpPr>
            <p:spPr>
              <a:xfrm>
                <a:off x="5804243" y="2915594"/>
                <a:ext cx="75074" cy="1222575"/>
              </a:xfrm>
              <a:prstGeom prst="rect">
                <a:avLst/>
              </a:prstGeom>
              <a:solidFill>
                <a:srgbClr val="CCE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170" name="Group 169">
                <a:extLst>
                  <a:ext uri="{FF2B5EF4-FFF2-40B4-BE49-F238E27FC236}">
                    <a16:creationId xmlns:a16="http://schemas.microsoft.com/office/drawing/2014/main" id="{88131E57-CDCE-1CDC-F296-3C6D1611BE6C}"/>
                  </a:ext>
                </a:extLst>
              </p:cNvPr>
              <p:cNvGrpSpPr/>
              <p:nvPr/>
            </p:nvGrpSpPr>
            <p:grpSpPr>
              <a:xfrm>
                <a:off x="3544888" y="4049667"/>
                <a:ext cx="1732461" cy="1080344"/>
                <a:chOff x="630298" y="3402275"/>
                <a:chExt cx="1913629" cy="1249385"/>
              </a:xfrm>
            </p:grpSpPr>
            <p:sp>
              <p:nvSpPr>
                <p:cNvPr id="200" name="Freeform 10">
                  <a:extLst>
                    <a:ext uri="{FF2B5EF4-FFF2-40B4-BE49-F238E27FC236}">
                      <a16:creationId xmlns:a16="http://schemas.microsoft.com/office/drawing/2014/main" id="{A8A77ABB-56D7-A4F0-0147-CB55566A26D4}"/>
                    </a:ext>
                  </a:extLst>
                </p:cNvPr>
                <p:cNvSpPr/>
                <p:nvPr/>
              </p:nvSpPr>
              <p:spPr>
                <a:xfrm rot="7436320">
                  <a:off x="1406917" y="3660710"/>
                  <a:ext cx="245416" cy="308611"/>
                </a:xfrm>
                <a:custGeom>
                  <a:avLst/>
                  <a:gdLst>
                    <a:gd name="connsiteX0" fmla="*/ 480405 w 600326"/>
                    <a:gd name="connsiteY0" fmla="*/ 0 h 1019331"/>
                    <a:gd name="connsiteX1" fmla="*/ 45690 w 600326"/>
                    <a:gd name="connsiteY1" fmla="*/ 389744 h 1019331"/>
                    <a:gd name="connsiteX2" fmla="*/ 75670 w 600326"/>
                    <a:gd name="connsiteY2" fmla="*/ 809469 h 1019331"/>
                    <a:gd name="connsiteX3" fmla="*/ 600326 w 600326"/>
                    <a:gd name="connsiteY3" fmla="*/ 1019331 h 1019331"/>
                    <a:gd name="connsiteX4" fmla="*/ 600326 w 600326"/>
                    <a:gd name="connsiteY4" fmla="*/ 1019331 h 101933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00326" h="1019331">
                      <a:moveTo>
                        <a:pt x="480405" y="0"/>
                      </a:moveTo>
                      <a:cubicBezTo>
                        <a:pt x="296775" y="127416"/>
                        <a:pt x="113146" y="254833"/>
                        <a:pt x="45690" y="389744"/>
                      </a:cubicBezTo>
                      <a:cubicBezTo>
                        <a:pt x="-21766" y="524656"/>
                        <a:pt x="-16769" y="704538"/>
                        <a:pt x="75670" y="809469"/>
                      </a:cubicBezTo>
                      <a:cubicBezTo>
                        <a:pt x="168109" y="914400"/>
                        <a:pt x="600326" y="1019331"/>
                        <a:pt x="600326" y="1019331"/>
                      </a:cubicBezTo>
                      <a:lnTo>
                        <a:pt x="600326" y="1019331"/>
                      </a:lnTo>
                    </a:path>
                  </a:pathLst>
                </a:custGeom>
                <a:noFill/>
                <a:ln w="19050">
                  <a:solidFill>
                    <a:schemeClr val="bg2">
                      <a:lumMod val="50000"/>
                    </a:schemeClr>
                  </a:solidFill>
                  <a:headEnd type="arrow" w="med" len="med"/>
                  <a:tailEnd type="none" w="med" len="med"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grpSp>
              <p:nvGrpSpPr>
                <p:cNvPr id="201" name="Group 200">
                  <a:extLst>
                    <a:ext uri="{FF2B5EF4-FFF2-40B4-BE49-F238E27FC236}">
                      <a16:creationId xmlns:a16="http://schemas.microsoft.com/office/drawing/2014/main" id="{D8F4FA41-3231-63CC-7577-6E88F4083FF8}"/>
                    </a:ext>
                  </a:extLst>
                </p:cNvPr>
                <p:cNvGrpSpPr/>
                <p:nvPr/>
              </p:nvGrpSpPr>
              <p:grpSpPr>
                <a:xfrm>
                  <a:off x="1312753" y="3402275"/>
                  <a:ext cx="993679" cy="284747"/>
                  <a:chOff x="3400022" y="3061472"/>
                  <a:chExt cx="1026039" cy="340418"/>
                </a:xfrm>
                <a:noFill/>
              </p:grpSpPr>
              <p:sp>
                <p:nvSpPr>
                  <p:cNvPr id="213" name="Rectangle 212">
                    <a:extLst>
                      <a:ext uri="{FF2B5EF4-FFF2-40B4-BE49-F238E27FC236}">
                        <a16:creationId xmlns:a16="http://schemas.microsoft.com/office/drawing/2014/main" id="{DFF41DFA-E1A4-9933-1DCB-D4BFD9C633EA}"/>
                      </a:ext>
                    </a:extLst>
                  </p:cNvPr>
                  <p:cNvSpPr/>
                  <p:nvPr/>
                </p:nvSpPr>
                <p:spPr>
                  <a:xfrm>
                    <a:off x="3482997" y="3132308"/>
                    <a:ext cx="775806" cy="162820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14" name="TextBox 213">
                    <a:extLst>
                      <a:ext uri="{FF2B5EF4-FFF2-40B4-BE49-F238E27FC236}">
                        <a16:creationId xmlns:a16="http://schemas.microsoft.com/office/drawing/2014/main" id="{87259059-FE60-A8A5-2C97-7E8F3A0927E3}"/>
                      </a:ext>
                    </a:extLst>
                  </p:cNvPr>
                  <p:cNvSpPr txBox="1"/>
                  <p:nvPr/>
                </p:nvSpPr>
                <p:spPr>
                  <a:xfrm>
                    <a:off x="3400022" y="3061472"/>
                    <a:ext cx="1026039" cy="340418"/>
                  </a:xfrm>
                  <a:prstGeom prst="rect">
                    <a:avLst/>
                  </a:prstGeom>
                  <a:grp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 Nova" panose="020B0504020202020204" pitchFamily="34" charset="0"/>
                      </a:rPr>
                      <a:t>PDZRhoGEF</a:t>
                    </a:r>
                    <a:endParaRPr lang="en-GB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grpSp>
              <p:nvGrpSpPr>
                <p:cNvPr id="202" name="Group 201">
                  <a:extLst>
                    <a:ext uri="{FF2B5EF4-FFF2-40B4-BE49-F238E27FC236}">
                      <a16:creationId xmlns:a16="http://schemas.microsoft.com/office/drawing/2014/main" id="{97E538BC-61EF-AFDC-E146-60EB14679E23}"/>
                    </a:ext>
                  </a:extLst>
                </p:cNvPr>
                <p:cNvGrpSpPr/>
                <p:nvPr/>
              </p:nvGrpSpPr>
              <p:grpSpPr>
                <a:xfrm>
                  <a:off x="1383110" y="3937481"/>
                  <a:ext cx="1160817" cy="284747"/>
                  <a:chOff x="1277830" y="3561466"/>
                  <a:chExt cx="1160817" cy="284747"/>
                </a:xfrm>
              </p:grpSpPr>
              <p:sp>
                <p:nvSpPr>
                  <p:cNvPr id="210" name="Rectangle 209">
                    <a:extLst>
                      <a:ext uri="{FF2B5EF4-FFF2-40B4-BE49-F238E27FC236}">
                        <a16:creationId xmlns:a16="http://schemas.microsoft.com/office/drawing/2014/main" id="{3235C180-C6C5-CF0C-5BD0-65B05952B378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527224" y="3439520"/>
                    <a:ext cx="166547" cy="563002"/>
                  </a:xfrm>
                  <a:prstGeom prst="rect">
                    <a:avLst/>
                  </a:prstGeom>
                  <a:noFill/>
                  <a:ln w="285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11" name="Rectangle 210">
                    <a:extLst>
                      <a:ext uri="{FF2B5EF4-FFF2-40B4-BE49-F238E27FC236}">
                        <a16:creationId xmlns:a16="http://schemas.microsoft.com/office/drawing/2014/main" id="{7B8B3947-8B6A-BCC0-96DE-254912E9CE2B}"/>
                      </a:ext>
                    </a:extLst>
                  </p:cNvPr>
                  <p:cNvSpPr/>
                  <p:nvPr/>
                </p:nvSpPr>
                <p:spPr>
                  <a:xfrm>
                    <a:off x="1346270" y="3654495"/>
                    <a:ext cx="602540" cy="14979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12" name="TextBox 211">
                    <a:extLst>
                      <a:ext uri="{FF2B5EF4-FFF2-40B4-BE49-F238E27FC236}">
                        <a16:creationId xmlns:a16="http://schemas.microsoft.com/office/drawing/2014/main" id="{1AFA130C-3F19-80FE-ADD9-665144D2A34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277830" y="3561466"/>
                    <a:ext cx="1160817" cy="284747"/>
                  </a:xfrm>
                  <a:prstGeom prst="rect">
                    <a:avLst/>
                  </a:prstGeom>
                  <a:noFill/>
                  <a:ln>
                    <a:noFill/>
                  </a:ln>
                  <a:scene3d>
                    <a:camera prst="orthographicFront"/>
                    <a:lightRig rig="threePt" dir="t"/>
                  </a:scene3d>
                  <a:sp3d prstMaterial="matte"/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r>
                      <a:rPr lang="en-GB" altLang="en-US" sz="1000" dirty="0" err="1">
                        <a:latin typeface="Arial Nova" panose="020B0504020202020204" pitchFamily="34" charset="0"/>
                      </a:rPr>
                      <a:t>RhoGTP</a:t>
                    </a:r>
                    <a:endParaRPr lang="en-GB" altLang="en-US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grpSp>
              <p:nvGrpSpPr>
                <p:cNvPr id="203" name="Group 202">
                  <a:extLst>
                    <a:ext uri="{FF2B5EF4-FFF2-40B4-BE49-F238E27FC236}">
                      <a16:creationId xmlns:a16="http://schemas.microsoft.com/office/drawing/2014/main" id="{2E242717-32AC-F8FA-F85C-3D4C17FAF92B}"/>
                    </a:ext>
                  </a:extLst>
                </p:cNvPr>
                <p:cNvGrpSpPr/>
                <p:nvPr/>
              </p:nvGrpSpPr>
              <p:grpSpPr>
                <a:xfrm>
                  <a:off x="1108356" y="4366914"/>
                  <a:ext cx="1053880" cy="284746"/>
                  <a:chOff x="3011589" y="3197325"/>
                  <a:chExt cx="1129311" cy="340419"/>
                </a:xfrm>
                <a:noFill/>
              </p:grpSpPr>
              <p:sp>
                <p:nvSpPr>
                  <p:cNvPr id="208" name="Rectangle 207">
                    <a:extLst>
                      <a:ext uri="{FF2B5EF4-FFF2-40B4-BE49-F238E27FC236}">
                        <a16:creationId xmlns:a16="http://schemas.microsoft.com/office/drawing/2014/main" id="{970C03D7-965C-3F11-46DC-528D69CC905B}"/>
                      </a:ext>
                    </a:extLst>
                  </p:cNvPr>
                  <p:cNvSpPr/>
                  <p:nvPr/>
                </p:nvSpPr>
                <p:spPr>
                  <a:xfrm>
                    <a:off x="3093516" y="3294583"/>
                    <a:ext cx="933751" cy="202022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09" name="TextBox 208">
                    <a:extLst>
                      <a:ext uri="{FF2B5EF4-FFF2-40B4-BE49-F238E27FC236}">
                        <a16:creationId xmlns:a16="http://schemas.microsoft.com/office/drawing/2014/main" id="{2E62317A-DD14-8120-57AE-0FACE542B193}"/>
                      </a:ext>
                    </a:extLst>
                  </p:cNvPr>
                  <p:cNvSpPr txBox="1"/>
                  <p:nvPr/>
                </p:nvSpPr>
                <p:spPr>
                  <a:xfrm>
                    <a:off x="3011589" y="3197325"/>
                    <a:ext cx="1129311" cy="340419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>
                        <a:latin typeface="Arial Nova" panose="020B0504020202020204" pitchFamily="34" charset="0"/>
                      </a:rPr>
                      <a:t>p190RhoGAP</a:t>
                    </a:r>
                  </a:p>
                </p:txBody>
              </p:sp>
            </p:grpSp>
            <p:sp>
              <p:nvSpPr>
                <p:cNvPr id="204" name="Rectangle 203">
                  <a:extLst>
                    <a:ext uri="{FF2B5EF4-FFF2-40B4-BE49-F238E27FC236}">
                      <a16:creationId xmlns:a16="http://schemas.microsoft.com/office/drawing/2014/main" id="{4712A7E1-356B-6458-6B61-219A83CD3502}"/>
                    </a:ext>
                  </a:extLst>
                </p:cNvPr>
                <p:cNvSpPr/>
                <p:nvPr/>
              </p:nvSpPr>
              <p:spPr>
                <a:xfrm>
                  <a:off x="709999" y="3913443"/>
                  <a:ext cx="578927" cy="204076"/>
                </a:xfrm>
                <a:prstGeom prst="rect">
                  <a:avLst/>
                </a:prstGeom>
                <a:solidFill>
                  <a:srgbClr val="FFCC9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205" name="TextBox 204">
                  <a:extLst>
                    <a:ext uri="{FF2B5EF4-FFF2-40B4-BE49-F238E27FC236}">
                      <a16:creationId xmlns:a16="http://schemas.microsoft.com/office/drawing/2014/main" id="{50B7DF78-7316-B5FE-1C08-50641CB0E03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4876" y="3736015"/>
                  <a:ext cx="204049" cy="284747"/>
                </a:xfrm>
                <a:prstGeom prst="rect">
                  <a:avLst/>
                </a:prstGeom>
                <a:noFill/>
                <a:ln>
                  <a:noFill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GB" altLang="en-US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D2E370A0-C2C6-55BA-2EBE-CA56E3545C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30298" y="3883815"/>
                  <a:ext cx="744020" cy="284747"/>
                </a:xfrm>
                <a:prstGeom prst="rect">
                  <a:avLst/>
                </a:prstGeom>
                <a:noFill/>
                <a:ln>
                  <a:noFill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r>
                    <a:rPr lang="en-GB" altLang="en-US" sz="1000" dirty="0" err="1">
                      <a:latin typeface="Arial Nova" panose="020B0504020202020204" pitchFamily="34" charset="0"/>
                    </a:rPr>
                    <a:t>RhoGDP</a:t>
                  </a:r>
                  <a:endParaRPr lang="en-GB" altLang="en-US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207" name="Freeform 10">
                  <a:extLst>
                    <a:ext uri="{FF2B5EF4-FFF2-40B4-BE49-F238E27FC236}">
                      <a16:creationId xmlns:a16="http://schemas.microsoft.com/office/drawing/2014/main" id="{9B264216-A599-DF4B-4118-5814FDD9EED8}"/>
                    </a:ext>
                  </a:extLst>
                </p:cNvPr>
                <p:cNvSpPr/>
                <p:nvPr/>
              </p:nvSpPr>
              <p:spPr>
                <a:xfrm rot="18052700">
                  <a:off x="1263577" y="4161828"/>
                  <a:ext cx="176866" cy="274634"/>
                </a:xfrm>
                <a:custGeom>
                  <a:avLst/>
                  <a:gdLst>
                    <a:gd name="connsiteX0" fmla="*/ 480405 w 600326"/>
                    <a:gd name="connsiteY0" fmla="*/ 0 h 1019331"/>
                    <a:gd name="connsiteX1" fmla="*/ 45690 w 600326"/>
                    <a:gd name="connsiteY1" fmla="*/ 389744 h 1019331"/>
                    <a:gd name="connsiteX2" fmla="*/ 75670 w 600326"/>
                    <a:gd name="connsiteY2" fmla="*/ 809469 h 1019331"/>
                    <a:gd name="connsiteX3" fmla="*/ 600326 w 600326"/>
                    <a:gd name="connsiteY3" fmla="*/ 1019331 h 1019331"/>
                    <a:gd name="connsiteX4" fmla="*/ 600326 w 600326"/>
                    <a:gd name="connsiteY4" fmla="*/ 1019331 h 101933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00326" h="1019331">
                      <a:moveTo>
                        <a:pt x="480405" y="0"/>
                      </a:moveTo>
                      <a:cubicBezTo>
                        <a:pt x="296775" y="127416"/>
                        <a:pt x="113146" y="254833"/>
                        <a:pt x="45690" y="389744"/>
                      </a:cubicBezTo>
                      <a:cubicBezTo>
                        <a:pt x="-21766" y="524656"/>
                        <a:pt x="-16769" y="704538"/>
                        <a:pt x="75670" y="809469"/>
                      </a:cubicBezTo>
                      <a:cubicBezTo>
                        <a:pt x="168109" y="914400"/>
                        <a:pt x="600326" y="1019331"/>
                        <a:pt x="600326" y="1019331"/>
                      </a:cubicBezTo>
                      <a:lnTo>
                        <a:pt x="600326" y="1019331"/>
                      </a:lnTo>
                    </a:path>
                  </a:pathLst>
                </a:custGeom>
                <a:noFill/>
                <a:ln w="19050">
                  <a:solidFill>
                    <a:schemeClr val="bg2">
                      <a:lumMod val="50000"/>
                    </a:schemeClr>
                  </a:solidFill>
                  <a:headEnd type="arrow" w="med" len="med"/>
                  <a:tailEnd type="none" w="med" len="med"/>
                </a:ln>
                <a:scene3d>
                  <a:camera prst="orthographicFront"/>
                  <a:lightRig rig="threePt" dir="t"/>
                </a:scene3d>
                <a:sp3d prstMaterial="matte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71" name="Group 170">
                <a:extLst>
                  <a:ext uri="{FF2B5EF4-FFF2-40B4-BE49-F238E27FC236}">
                    <a16:creationId xmlns:a16="http://schemas.microsoft.com/office/drawing/2014/main" id="{E0015EE8-4E47-F525-0513-0567448AD6AC}"/>
                  </a:ext>
                </a:extLst>
              </p:cNvPr>
              <p:cNvGrpSpPr/>
              <p:nvPr/>
            </p:nvGrpSpPr>
            <p:grpSpPr>
              <a:xfrm>
                <a:off x="5752490" y="4298423"/>
                <a:ext cx="414877" cy="362526"/>
                <a:chOff x="4221628" y="2531020"/>
                <a:chExt cx="458262" cy="419250"/>
              </a:xfrm>
            </p:grpSpPr>
            <p:grpSp>
              <p:nvGrpSpPr>
                <p:cNvPr id="194" name="Group 193">
                  <a:extLst>
                    <a:ext uri="{FF2B5EF4-FFF2-40B4-BE49-F238E27FC236}">
                      <a16:creationId xmlns:a16="http://schemas.microsoft.com/office/drawing/2014/main" id="{1E86238E-0AF1-B4AE-0099-2C2BACA88C55}"/>
                    </a:ext>
                  </a:extLst>
                </p:cNvPr>
                <p:cNvGrpSpPr/>
                <p:nvPr/>
              </p:nvGrpSpPr>
              <p:grpSpPr>
                <a:xfrm>
                  <a:off x="4235107" y="2531020"/>
                  <a:ext cx="444783" cy="284746"/>
                  <a:chOff x="6416383" y="7776963"/>
                  <a:chExt cx="435769" cy="340419"/>
                </a:xfrm>
              </p:grpSpPr>
              <p:sp>
                <p:nvSpPr>
                  <p:cNvPr id="198" name="Oval 197">
                    <a:extLst>
                      <a:ext uri="{FF2B5EF4-FFF2-40B4-BE49-F238E27FC236}">
                        <a16:creationId xmlns:a16="http://schemas.microsoft.com/office/drawing/2014/main" id="{DE49E450-547B-D24D-7756-B1848818F77E}"/>
                      </a:ext>
                    </a:extLst>
                  </p:cNvPr>
                  <p:cNvSpPr/>
                  <p:nvPr/>
                </p:nvSpPr>
                <p:spPr>
                  <a:xfrm>
                    <a:off x="6475686" y="7867431"/>
                    <a:ext cx="288736" cy="179129"/>
                  </a:xfrm>
                  <a:prstGeom prst="ellipse">
                    <a:avLst/>
                  </a:prstGeom>
                  <a:solidFill>
                    <a:srgbClr val="CCFFFF"/>
                  </a:solidFill>
                  <a:ln w="12700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 dirty="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199" name="TextBox 198">
                    <a:extLst>
                      <a:ext uri="{FF2B5EF4-FFF2-40B4-BE49-F238E27FC236}">
                        <a16:creationId xmlns:a16="http://schemas.microsoft.com/office/drawing/2014/main" id="{038CF8A4-0645-EBB7-4C90-A3CB7E979698}"/>
                      </a:ext>
                    </a:extLst>
                  </p:cNvPr>
                  <p:cNvSpPr txBox="1"/>
                  <p:nvPr/>
                </p:nvSpPr>
                <p:spPr>
                  <a:xfrm>
                    <a:off x="6416383" y="7776963"/>
                    <a:ext cx="435769" cy="3404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 Nova" panose="020B0504020202020204" pitchFamily="34" charset="0"/>
                      </a:rPr>
                      <a:t>Rac</a:t>
                    </a:r>
                    <a:endParaRPr lang="en-GB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  <p:grpSp>
              <p:nvGrpSpPr>
                <p:cNvPr id="195" name="Group 194">
                  <a:extLst>
                    <a:ext uri="{FF2B5EF4-FFF2-40B4-BE49-F238E27FC236}">
                      <a16:creationId xmlns:a16="http://schemas.microsoft.com/office/drawing/2014/main" id="{0F11B1F8-C404-61B1-0235-FB89065BB879}"/>
                    </a:ext>
                  </a:extLst>
                </p:cNvPr>
                <p:cNvGrpSpPr/>
                <p:nvPr/>
              </p:nvGrpSpPr>
              <p:grpSpPr>
                <a:xfrm>
                  <a:off x="4221628" y="2665523"/>
                  <a:ext cx="455407" cy="284747"/>
                  <a:chOff x="4731928" y="2657993"/>
                  <a:chExt cx="455407" cy="284747"/>
                </a:xfrm>
              </p:grpSpPr>
              <p:sp>
                <p:nvSpPr>
                  <p:cNvPr id="196" name="Oval 195">
                    <a:extLst>
                      <a:ext uri="{FF2B5EF4-FFF2-40B4-BE49-F238E27FC236}">
                        <a16:creationId xmlns:a16="http://schemas.microsoft.com/office/drawing/2014/main" id="{D766ACD8-9D87-D182-689B-D573DAB2EB6D}"/>
                      </a:ext>
                    </a:extLst>
                  </p:cNvPr>
                  <p:cNvSpPr/>
                  <p:nvPr/>
                </p:nvSpPr>
                <p:spPr>
                  <a:xfrm>
                    <a:off x="4796420" y="2732210"/>
                    <a:ext cx="304225" cy="157686"/>
                  </a:xfrm>
                  <a:prstGeom prst="ellipse">
                    <a:avLst/>
                  </a:prstGeom>
                  <a:solidFill>
                    <a:srgbClr val="CCECFF"/>
                  </a:solidFill>
                  <a:ln w="12700">
                    <a:solidFill>
                      <a:srgbClr val="3399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197" name="TextBox 196">
                    <a:extLst>
                      <a:ext uri="{FF2B5EF4-FFF2-40B4-BE49-F238E27FC236}">
                        <a16:creationId xmlns:a16="http://schemas.microsoft.com/office/drawing/2014/main" id="{916096E0-77E8-CCFB-1B51-8C15429FCBB9}"/>
                      </a:ext>
                    </a:extLst>
                  </p:cNvPr>
                  <p:cNvSpPr txBox="1"/>
                  <p:nvPr/>
                </p:nvSpPr>
                <p:spPr>
                  <a:xfrm>
                    <a:off x="4731928" y="2657993"/>
                    <a:ext cx="455407" cy="28474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 Nova" panose="020B0504020202020204" pitchFamily="34" charset="0"/>
                      </a:rPr>
                      <a:t>Rnd</a:t>
                    </a:r>
                    <a:endParaRPr lang="en-GB" sz="1000" dirty="0">
                      <a:latin typeface="Arial Nova" panose="020B0504020202020204" pitchFamily="34" charset="0"/>
                    </a:endParaRPr>
                  </a:p>
                </p:txBody>
              </p:sp>
            </p:grpSp>
          </p:grp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78BE56D7-B3EE-F19C-B976-474684063D3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42322" y="4088265"/>
                <a:ext cx="800727" cy="246221"/>
              </a:xfrm>
              <a:prstGeom prst="rect">
                <a:avLst/>
              </a:prstGeom>
              <a:noFill/>
              <a:ln>
                <a:noFill/>
              </a:ln>
              <a:scene3d>
                <a:camera prst="orthographicFront"/>
                <a:lightRig rig="threePt" dir="t"/>
              </a:scene3d>
              <a:sp3d prstMaterial="matte"/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en-GB" altLang="en-US" sz="1000" dirty="0" err="1">
                    <a:solidFill>
                      <a:schemeClr val="bg2">
                        <a:lumMod val="90000"/>
                      </a:schemeClr>
                    </a:solidFill>
                    <a:latin typeface="Arial Nova" panose="020B0504020202020204" pitchFamily="34" charset="0"/>
                  </a:rPr>
                  <a:t>RapGDP</a:t>
                </a:r>
                <a:endParaRPr lang="en-GB" altLang="en-US" sz="1000" dirty="0">
                  <a:solidFill>
                    <a:schemeClr val="bg2">
                      <a:lumMod val="90000"/>
                    </a:schemeClr>
                  </a:solidFill>
                  <a:latin typeface="Arial Nova" panose="020B05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FA11BE6-1669-62CC-4341-A60EECD5190F}"/>
                  </a:ext>
                </a:extLst>
              </p:cNvPr>
              <p:cNvSpPr txBox="1"/>
              <p:nvPr/>
            </p:nvSpPr>
            <p:spPr>
              <a:xfrm>
                <a:off x="4016665" y="3019001"/>
                <a:ext cx="2856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B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6966DB8F-5362-6336-E03E-1EF7C44D1619}"/>
                  </a:ext>
                </a:extLst>
              </p:cNvPr>
              <p:cNvSpPr txBox="1"/>
              <p:nvPr/>
            </p:nvSpPr>
            <p:spPr>
              <a:xfrm>
                <a:off x="5566405" y="3610764"/>
                <a:ext cx="53247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endParaRPr lang="en-GB" sz="1000" dirty="0">
                  <a:solidFill>
                    <a:srgbClr val="00B0F0"/>
                  </a:solidFill>
                  <a:latin typeface="Arial Nova" panose="020B05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FDBF307-E3DC-CB1A-D8D3-0FE6739F1C44}"/>
                  </a:ext>
                </a:extLst>
              </p:cNvPr>
              <p:cNvSpPr txBox="1"/>
              <p:nvPr/>
            </p:nvSpPr>
            <p:spPr>
              <a:xfrm>
                <a:off x="7589741" y="4505559"/>
                <a:ext cx="738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Invasion</a:t>
                </a:r>
              </a:p>
            </p:txBody>
          </p:sp>
        </p:grpSp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6091321E-1210-F194-FB35-942958C5E300}"/>
                </a:ext>
              </a:extLst>
            </p:cNvPr>
            <p:cNvGrpSpPr/>
            <p:nvPr/>
          </p:nvGrpSpPr>
          <p:grpSpPr>
            <a:xfrm>
              <a:off x="5664572" y="2644684"/>
              <a:ext cx="187765" cy="682705"/>
              <a:chOff x="4879335" y="167302"/>
              <a:chExt cx="471665" cy="999836"/>
            </a:xfrm>
          </p:grpSpPr>
          <p:grpSp>
            <p:nvGrpSpPr>
              <p:cNvPr id="178" name="Group 177">
                <a:extLst>
                  <a:ext uri="{FF2B5EF4-FFF2-40B4-BE49-F238E27FC236}">
                    <a16:creationId xmlns:a16="http://schemas.microsoft.com/office/drawing/2014/main" id="{EA8DFE47-68DA-C9D3-B931-16CC48A5EB9F}"/>
                  </a:ext>
                </a:extLst>
              </p:cNvPr>
              <p:cNvGrpSpPr/>
              <p:nvPr/>
            </p:nvGrpSpPr>
            <p:grpSpPr>
              <a:xfrm>
                <a:off x="4879335" y="168197"/>
                <a:ext cx="339756" cy="998941"/>
                <a:chOff x="9335386" y="0"/>
                <a:chExt cx="339756" cy="998941"/>
              </a:xfrm>
            </p:grpSpPr>
            <p:sp>
              <p:nvSpPr>
                <p:cNvPr id="182" name="Oval 181">
                  <a:extLst>
                    <a:ext uri="{FF2B5EF4-FFF2-40B4-BE49-F238E27FC236}">
                      <a16:creationId xmlns:a16="http://schemas.microsoft.com/office/drawing/2014/main" id="{81BD6290-EEBE-4026-F9FB-8F52577E2F0E}"/>
                    </a:ext>
                  </a:extLst>
                </p:cNvPr>
                <p:cNvSpPr/>
                <p:nvPr/>
              </p:nvSpPr>
              <p:spPr>
                <a:xfrm>
                  <a:off x="9335386" y="347330"/>
                  <a:ext cx="339756" cy="651611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rgbClr val="FFC000">
                        <a:shade val="30000"/>
                        <a:satMod val="115000"/>
                      </a:srgbClr>
                    </a:gs>
                    <a:gs pos="50000">
                      <a:srgbClr val="FFC000">
                        <a:shade val="67500"/>
                        <a:satMod val="115000"/>
                      </a:srgbClr>
                    </a:gs>
                    <a:gs pos="100000">
                      <a:srgbClr val="FFC000">
                        <a:shade val="100000"/>
                        <a:satMod val="115000"/>
                      </a:srgbClr>
                    </a:gs>
                  </a:gsLst>
                  <a:lin ang="108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83" name="Rectangle 182">
                  <a:extLst>
                    <a:ext uri="{FF2B5EF4-FFF2-40B4-BE49-F238E27FC236}">
                      <a16:creationId xmlns:a16="http://schemas.microsoft.com/office/drawing/2014/main" id="{171B93AF-52A1-A115-9F35-9525078DD6B9}"/>
                    </a:ext>
                  </a:extLst>
                </p:cNvPr>
                <p:cNvSpPr/>
                <p:nvPr/>
              </p:nvSpPr>
              <p:spPr>
                <a:xfrm>
                  <a:off x="9448797" y="0"/>
                  <a:ext cx="97037" cy="465463"/>
                </a:xfrm>
                <a:prstGeom prst="rect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62C2712D-B987-9743-0686-2DDAC0F46061}"/>
                  </a:ext>
                </a:extLst>
              </p:cNvPr>
              <p:cNvGrpSpPr/>
              <p:nvPr/>
            </p:nvGrpSpPr>
            <p:grpSpPr>
              <a:xfrm>
                <a:off x="5011244" y="167302"/>
                <a:ext cx="339756" cy="998941"/>
                <a:chOff x="9335386" y="0"/>
                <a:chExt cx="339756" cy="998941"/>
              </a:xfrm>
            </p:grpSpPr>
            <p:sp>
              <p:nvSpPr>
                <p:cNvPr id="180" name="Oval 179">
                  <a:extLst>
                    <a:ext uri="{FF2B5EF4-FFF2-40B4-BE49-F238E27FC236}">
                      <a16:creationId xmlns:a16="http://schemas.microsoft.com/office/drawing/2014/main" id="{0C79DD54-E01D-D96D-DC8F-0BB29054F504}"/>
                    </a:ext>
                  </a:extLst>
                </p:cNvPr>
                <p:cNvSpPr/>
                <p:nvPr/>
              </p:nvSpPr>
              <p:spPr>
                <a:xfrm>
                  <a:off x="9335386" y="347330"/>
                  <a:ext cx="339756" cy="651611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rgbClr val="FFC000">
                        <a:shade val="30000"/>
                        <a:satMod val="115000"/>
                      </a:srgbClr>
                    </a:gs>
                    <a:gs pos="50000">
                      <a:srgbClr val="FFC000">
                        <a:shade val="67500"/>
                        <a:satMod val="115000"/>
                      </a:srgbClr>
                    </a:gs>
                    <a:gs pos="100000">
                      <a:srgbClr val="FFC000">
                        <a:shade val="100000"/>
                        <a:satMod val="115000"/>
                      </a:srgbClr>
                    </a:gs>
                  </a:gsLst>
                  <a:lin ang="108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81" name="Rectangle 180">
                  <a:extLst>
                    <a:ext uri="{FF2B5EF4-FFF2-40B4-BE49-F238E27FC236}">
                      <a16:creationId xmlns:a16="http://schemas.microsoft.com/office/drawing/2014/main" id="{7B492D03-03EE-20AE-FAD7-649F1B420815}"/>
                    </a:ext>
                  </a:extLst>
                </p:cNvPr>
                <p:cNvSpPr/>
                <p:nvPr/>
              </p:nvSpPr>
              <p:spPr>
                <a:xfrm>
                  <a:off x="9448797" y="0"/>
                  <a:ext cx="97037" cy="465463"/>
                </a:xfrm>
                <a:prstGeom prst="rect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430557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3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1-04T17:17:56Z</dcterms:created>
  <dcterms:modified xsi:type="dcterms:W3CDTF">2023-01-04T17:18:48Z</dcterms:modified>
</cp:coreProperties>
</file>